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8"/>
  </p:notesMasterIdLst>
  <p:sldIdLst>
    <p:sldId id="256" r:id="rId5"/>
    <p:sldId id="274" r:id="rId6"/>
    <p:sldId id="277"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5F23DA0-B7EF-0824-967C-5E053D4C2EA5}" v="3" dt="2024-05-08T23:48:47.990"/>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oshi, Renu" userId="834bd94a-69d6-44cb-9a70-3886341f17de" providerId="ADAL" clId="{6E456088-3655-4EB0-BC1D-DF32F39F5A2E}"/>
    <pc:docChg chg="custSel modSld">
      <pc:chgData name="Joshi, Renu" userId="834bd94a-69d6-44cb-9a70-3886341f17de" providerId="ADAL" clId="{6E456088-3655-4EB0-BC1D-DF32F39F5A2E}" dt="2024-04-16T21:20:05.357" v="128" actId="113"/>
      <pc:docMkLst>
        <pc:docMk/>
      </pc:docMkLst>
      <pc:sldChg chg="modSp mod">
        <pc:chgData name="Joshi, Renu" userId="834bd94a-69d6-44cb-9a70-3886341f17de" providerId="ADAL" clId="{6E456088-3655-4EB0-BC1D-DF32F39F5A2E}" dt="2024-04-16T21:20:05.357" v="128" actId="113"/>
        <pc:sldMkLst>
          <pc:docMk/>
          <pc:sldMk cId="2222494559" sldId="274"/>
        </pc:sldMkLst>
        <pc:spChg chg="mod">
          <ac:chgData name="Joshi, Renu" userId="834bd94a-69d6-44cb-9a70-3886341f17de" providerId="ADAL" clId="{6E456088-3655-4EB0-BC1D-DF32F39F5A2E}" dt="2024-04-16T21:20:05.357" v="128" actId="113"/>
          <ac:spMkLst>
            <pc:docMk/>
            <pc:sldMk cId="2222494559" sldId="274"/>
            <ac:spMk id="2" creationId="{B89276B1-CD70-230A-B22D-C498614C64D9}"/>
          </ac:spMkLst>
        </pc:spChg>
      </pc:sldChg>
    </pc:docChg>
  </pc:docChgLst>
  <pc:docChgLst>
    <pc:chgData name="Joshi, Renu" userId="834bd94a-69d6-44cb-9a70-3886341f17de" providerId="ADAL" clId="{86E4CED7-BE8F-4E23-B6DF-79546BF4EB2B}"/>
    <pc:docChg chg="undo custSel modSld">
      <pc:chgData name="Joshi, Renu" userId="834bd94a-69d6-44cb-9a70-3886341f17de" providerId="ADAL" clId="{86E4CED7-BE8F-4E23-B6DF-79546BF4EB2B}" dt="2024-04-16T21:32:59.126" v="4" actId="20577"/>
      <pc:docMkLst>
        <pc:docMk/>
      </pc:docMkLst>
      <pc:sldChg chg="modSp mod">
        <pc:chgData name="Joshi, Renu" userId="834bd94a-69d6-44cb-9a70-3886341f17de" providerId="ADAL" clId="{86E4CED7-BE8F-4E23-B6DF-79546BF4EB2B}" dt="2024-04-16T21:32:59.126" v="4" actId="20577"/>
        <pc:sldMkLst>
          <pc:docMk/>
          <pc:sldMk cId="2222494559" sldId="274"/>
        </pc:sldMkLst>
        <pc:spChg chg="mod">
          <ac:chgData name="Joshi, Renu" userId="834bd94a-69d6-44cb-9a70-3886341f17de" providerId="ADAL" clId="{86E4CED7-BE8F-4E23-B6DF-79546BF4EB2B}" dt="2024-04-16T21:32:59.126" v="4" actId="20577"/>
          <ac:spMkLst>
            <pc:docMk/>
            <pc:sldMk cId="2222494559" sldId="274"/>
            <ac:spMk id="2" creationId="{B89276B1-CD70-230A-B22D-C498614C64D9}"/>
          </ac:spMkLst>
        </pc:spChg>
      </pc:sldChg>
    </pc:docChg>
  </pc:docChgLst>
  <pc:docChgLst>
    <pc:chgData name="Zaidi, Sadia" userId="145bb054-69df-4ca4-bbf9-5b2a9f131ead" providerId="ADAL" clId="{5704B46D-223A-314A-AACA-2EB1E17FF920}"/>
    <pc:docChg chg="delSld modSld">
      <pc:chgData name="Zaidi, Sadia" userId="145bb054-69df-4ca4-bbf9-5b2a9f131ead" providerId="ADAL" clId="{5704B46D-223A-314A-AACA-2EB1E17FF920}" dt="2024-04-29T13:16:12.103" v="291" actId="113"/>
      <pc:docMkLst>
        <pc:docMk/>
      </pc:docMkLst>
      <pc:sldChg chg="del">
        <pc:chgData name="Zaidi, Sadia" userId="145bb054-69df-4ca4-bbf9-5b2a9f131ead" providerId="ADAL" clId="{5704B46D-223A-314A-AACA-2EB1E17FF920}" dt="2024-04-16T21:31:03.041" v="1" actId="2696"/>
        <pc:sldMkLst>
          <pc:docMk/>
          <pc:sldMk cId="1831436982" sldId="257"/>
        </pc:sldMkLst>
      </pc:sldChg>
      <pc:sldChg chg="del">
        <pc:chgData name="Zaidi, Sadia" userId="145bb054-69df-4ca4-bbf9-5b2a9f131ead" providerId="ADAL" clId="{5704B46D-223A-314A-AACA-2EB1E17FF920}" dt="2024-04-16T21:31:03.060" v="2" actId="2696"/>
        <pc:sldMkLst>
          <pc:docMk/>
          <pc:sldMk cId="2790155969" sldId="258"/>
        </pc:sldMkLst>
      </pc:sldChg>
      <pc:sldChg chg="del">
        <pc:chgData name="Zaidi, Sadia" userId="145bb054-69df-4ca4-bbf9-5b2a9f131ead" providerId="ADAL" clId="{5704B46D-223A-314A-AACA-2EB1E17FF920}" dt="2024-04-16T21:31:03.101" v="8" actId="2696"/>
        <pc:sldMkLst>
          <pc:docMk/>
          <pc:sldMk cId="512149448" sldId="259"/>
        </pc:sldMkLst>
      </pc:sldChg>
      <pc:sldChg chg="del">
        <pc:chgData name="Zaidi, Sadia" userId="145bb054-69df-4ca4-bbf9-5b2a9f131ead" providerId="ADAL" clId="{5704B46D-223A-314A-AACA-2EB1E17FF920}" dt="2024-04-16T21:31:03.063" v="3" actId="2696"/>
        <pc:sldMkLst>
          <pc:docMk/>
          <pc:sldMk cId="2071285396" sldId="260"/>
        </pc:sldMkLst>
      </pc:sldChg>
      <pc:sldChg chg="del">
        <pc:chgData name="Zaidi, Sadia" userId="145bb054-69df-4ca4-bbf9-5b2a9f131ead" providerId="ADAL" clId="{5704B46D-223A-314A-AACA-2EB1E17FF920}" dt="2024-04-16T21:31:03.067" v="4" actId="2696"/>
        <pc:sldMkLst>
          <pc:docMk/>
          <pc:sldMk cId="1745276513" sldId="261"/>
        </pc:sldMkLst>
      </pc:sldChg>
      <pc:sldChg chg="del">
        <pc:chgData name="Zaidi, Sadia" userId="145bb054-69df-4ca4-bbf9-5b2a9f131ead" providerId="ADAL" clId="{5704B46D-223A-314A-AACA-2EB1E17FF920}" dt="2024-04-16T21:31:03.118" v="10" actId="2696"/>
        <pc:sldMkLst>
          <pc:docMk/>
          <pc:sldMk cId="2248017742" sldId="263"/>
        </pc:sldMkLst>
      </pc:sldChg>
      <pc:sldChg chg="del">
        <pc:chgData name="Zaidi, Sadia" userId="145bb054-69df-4ca4-bbf9-5b2a9f131ead" providerId="ADAL" clId="{5704B46D-223A-314A-AACA-2EB1E17FF920}" dt="2024-04-16T21:31:03.073" v="6" actId="2696"/>
        <pc:sldMkLst>
          <pc:docMk/>
          <pc:sldMk cId="624350079" sldId="264"/>
        </pc:sldMkLst>
      </pc:sldChg>
      <pc:sldChg chg="del">
        <pc:chgData name="Zaidi, Sadia" userId="145bb054-69df-4ca4-bbf9-5b2a9f131ead" providerId="ADAL" clId="{5704B46D-223A-314A-AACA-2EB1E17FF920}" dt="2024-04-16T21:31:03.115" v="9" actId="2696"/>
        <pc:sldMkLst>
          <pc:docMk/>
          <pc:sldMk cId="4053584341" sldId="266"/>
        </pc:sldMkLst>
      </pc:sldChg>
      <pc:sldChg chg="del">
        <pc:chgData name="Zaidi, Sadia" userId="145bb054-69df-4ca4-bbf9-5b2a9f131ead" providerId="ADAL" clId="{5704B46D-223A-314A-AACA-2EB1E17FF920}" dt="2024-04-16T21:31:03.121" v="11" actId="2696"/>
        <pc:sldMkLst>
          <pc:docMk/>
          <pc:sldMk cId="188638811" sldId="267"/>
        </pc:sldMkLst>
      </pc:sldChg>
      <pc:sldChg chg="del">
        <pc:chgData name="Zaidi, Sadia" userId="145bb054-69df-4ca4-bbf9-5b2a9f131ead" providerId="ADAL" clId="{5704B46D-223A-314A-AACA-2EB1E17FF920}" dt="2024-04-16T21:31:03.143" v="13" actId="2696"/>
        <pc:sldMkLst>
          <pc:docMk/>
          <pc:sldMk cId="3860122584" sldId="268"/>
        </pc:sldMkLst>
      </pc:sldChg>
      <pc:sldChg chg="del">
        <pc:chgData name="Zaidi, Sadia" userId="145bb054-69df-4ca4-bbf9-5b2a9f131ead" providerId="ADAL" clId="{5704B46D-223A-314A-AACA-2EB1E17FF920}" dt="2024-04-16T21:31:03.123" v="12" actId="2696"/>
        <pc:sldMkLst>
          <pc:docMk/>
          <pc:sldMk cId="2604268465" sldId="269"/>
        </pc:sldMkLst>
      </pc:sldChg>
      <pc:sldChg chg="del">
        <pc:chgData name="Zaidi, Sadia" userId="145bb054-69df-4ca4-bbf9-5b2a9f131ead" providerId="ADAL" clId="{5704B46D-223A-314A-AACA-2EB1E17FF920}" dt="2024-04-16T21:31:03.070" v="5" actId="2696"/>
        <pc:sldMkLst>
          <pc:docMk/>
          <pc:sldMk cId="4106918259" sldId="270"/>
        </pc:sldMkLst>
      </pc:sldChg>
      <pc:sldChg chg="del">
        <pc:chgData name="Zaidi, Sadia" userId="145bb054-69df-4ca4-bbf9-5b2a9f131ead" providerId="ADAL" clId="{5704B46D-223A-314A-AACA-2EB1E17FF920}" dt="2024-04-16T21:31:03.076" v="7" actId="2696"/>
        <pc:sldMkLst>
          <pc:docMk/>
          <pc:sldMk cId="3597123633" sldId="271"/>
        </pc:sldMkLst>
      </pc:sldChg>
      <pc:sldChg chg="del">
        <pc:chgData name="Zaidi, Sadia" userId="145bb054-69df-4ca4-bbf9-5b2a9f131ead" providerId="ADAL" clId="{5704B46D-223A-314A-AACA-2EB1E17FF920}" dt="2024-04-16T21:31:03.167" v="14" actId="2696"/>
        <pc:sldMkLst>
          <pc:docMk/>
          <pc:sldMk cId="254479069" sldId="272"/>
        </pc:sldMkLst>
      </pc:sldChg>
      <pc:sldChg chg="modSp mod">
        <pc:chgData name="Zaidi, Sadia" userId="145bb054-69df-4ca4-bbf9-5b2a9f131ead" providerId="ADAL" clId="{5704B46D-223A-314A-AACA-2EB1E17FF920}" dt="2024-04-29T13:16:12.103" v="291" actId="113"/>
        <pc:sldMkLst>
          <pc:docMk/>
          <pc:sldMk cId="2222494559" sldId="274"/>
        </pc:sldMkLst>
        <pc:spChg chg="mod">
          <ac:chgData name="Zaidi, Sadia" userId="145bb054-69df-4ca4-bbf9-5b2a9f131ead" providerId="ADAL" clId="{5704B46D-223A-314A-AACA-2EB1E17FF920}" dt="2024-04-29T13:16:12.103" v="291" actId="113"/>
          <ac:spMkLst>
            <pc:docMk/>
            <pc:sldMk cId="2222494559" sldId="274"/>
            <ac:spMk id="2" creationId="{B89276B1-CD70-230A-B22D-C498614C64D9}"/>
          </ac:spMkLst>
        </pc:spChg>
        <pc:spChg chg="mod">
          <ac:chgData name="Zaidi, Sadia" userId="145bb054-69df-4ca4-bbf9-5b2a9f131ead" providerId="ADAL" clId="{5704B46D-223A-314A-AACA-2EB1E17FF920}" dt="2024-04-25T02:39:56.740" v="277" actId="20577"/>
          <ac:spMkLst>
            <pc:docMk/>
            <pc:sldMk cId="2222494559" sldId="274"/>
            <ac:spMk id="24" creationId="{B1A1BFE8-1A2A-58FD-D67D-8EAB58A7B364}"/>
          </ac:spMkLst>
        </pc:spChg>
        <pc:spChg chg="mod">
          <ac:chgData name="Zaidi, Sadia" userId="145bb054-69df-4ca4-bbf9-5b2a9f131ead" providerId="ADAL" clId="{5704B46D-223A-314A-AACA-2EB1E17FF920}" dt="2024-04-24T17:29:03.225" v="234" actId="1036"/>
          <ac:spMkLst>
            <pc:docMk/>
            <pc:sldMk cId="2222494559" sldId="274"/>
            <ac:spMk id="25" creationId="{8444DA4E-CB29-261D-BBB8-4C6631F20122}"/>
          </ac:spMkLst>
        </pc:spChg>
        <pc:spChg chg="mod">
          <ac:chgData name="Zaidi, Sadia" userId="145bb054-69df-4ca4-bbf9-5b2a9f131ead" providerId="ADAL" clId="{5704B46D-223A-314A-AACA-2EB1E17FF920}" dt="2024-04-24T17:29:03.225" v="234" actId="1036"/>
          <ac:spMkLst>
            <pc:docMk/>
            <pc:sldMk cId="2222494559" sldId="274"/>
            <ac:spMk id="26" creationId="{D1B855C3-F55D-32CC-59AD-4D821999C7E7}"/>
          </ac:spMkLst>
        </pc:spChg>
        <pc:picChg chg="mod">
          <ac:chgData name="Zaidi, Sadia" userId="145bb054-69df-4ca4-bbf9-5b2a9f131ead" providerId="ADAL" clId="{5704B46D-223A-314A-AACA-2EB1E17FF920}" dt="2024-04-24T17:29:03.225" v="234" actId="1036"/>
          <ac:picMkLst>
            <pc:docMk/>
            <pc:sldMk cId="2222494559" sldId="274"/>
            <ac:picMk id="9" creationId="{66428C27-3F50-9859-D2D4-87AC7E0FE194}"/>
          </ac:picMkLst>
        </pc:picChg>
        <pc:picChg chg="mod">
          <ac:chgData name="Zaidi, Sadia" userId="145bb054-69df-4ca4-bbf9-5b2a9f131ead" providerId="ADAL" clId="{5704B46D-223A-314A-AACA-2EB1E17FF920}" dt="2024-04-24T17:29:03.225" v="234" actId="1036"/>
          <ac:picMkLst>
            <pc:docMk/>
            <pc:sldMk cId="2222494559" sldId="274"/>
            <ac:picMk id="16" creationId="{AE4B9BCE-3E4D-2366-895C-A69BDE232695}"/>
          </ac:picMkLst>
        </pc:picChg>
        <pc:picChg chg="mod">
          <ac:chgData name="Zaidi, Sadia" userId="145bb054-69df-4ca4-bbf9-5b2a9f131ead" providerId="ADAL" clId="{5704B46D-223A-314A-AACA-2EB1E17FF920}" dt="2024-04-24T17:29:03.225" v="234" actId="1036"/>
          <ac:picMkLst>
            <pc:docMk/>
            <pc:sldMk cId="2222494559" sldId="274"/>
            <ac:picMk id="17" creationId="{700667C0-AF05-20E4-9489-6B0AB26A3941}"/>
          </ac:picMkLst>
        </pc:picChg>
      </pc:sldChg>
      <pc:sldChg chg="del">
        <pc:chgData name="Zaidi, Sadia" userId="145bb054-69df-4ca4-bbf9-5b2a9f131ead" providerId="ADAL" clId="{5704B46D-223A-314A-AACA-2EB1E17FF920}" dt="2024-04-16T21:31:03.019" v="0" actId="2696"/>
        <pc:sldMkLst>
          <pc:docMk/>
          <pc:sldMk cId="2967016943" sldId="275"/>
        </pc:sldMkLst>
      </pc:sldChg>
    </pc:docChg>
  </pc:docChgLst>
  <pc:docChgLst>
    <pc:chgData name="Joshi, Renu" userId="S::renu.joshi@otsuka-oph.com::834bd94a-69d6-44cb-9a70-3886341f17de" providerId="AD" clId="Web-{831F57A2-6E39-4CCD-9AB2-8EB27AB9C711}"/>
    <pc:docChg chg="modSld">
      <pc:chgData name="Joshi, Renu" userId="S::renu.joshi@otsuka-oph.com::834bd94a-69d6-44cb-9a70-3886341f17de" providerId="AD" clId="Web-{831F57A2-6E39-4CCD-9AB2-8EB27AB9C711}" dt="2024-04-16T20:44:03.406" v="11" actId="20577"/>
      <pc:docMkLst>
        <pc:docMk/>
      </pc:docMkLst>
      <pc:sldChg chg="modSp">
        <pc:chgData name="Joshi, Renu" userId="S::renu.joshi@otsuka-oph.com::834bd94a-69d6-44cb-9a70-3886341f17de" providerId="AD" clId="Web-{831F57A2-6E39-4CCD-9AB2-8EB27AB9C711}" dt="2024-04-16T20:44:03.406" v="11" actId="20577"/>
        <pc:sldMkLst>
          <pc:docMk/>
          <pc:sldMk cId="2222494559" sldId="274"/>
        </pc:sldMkLst>
        <pc:spChg chg="mod">
          <ac:chgData name="Joshi, Renu" userId="S::renu.joshi@otsuka-oph.com::834bd94a-69d6-44cb-9a70-3886341f17de" providerId="AD" clId="Web-{831F57A2-6E39-4CCD-9AB2-8EB27AB9C711}" dt="2024-04-16T20:44:03.406" v="11" actId="20577"/>
          <ac:spMkLst>
            <pc:docMk/>
            <pc:sldMk cId="2222494559" sldId="274"/>
            <ac:spMk id="2" creationId="{B89276B1-CD70-230A-B22D-C498614C64D9}"/>
          </ac:spMkLst>
        </pc:spChg>
      </pc:sldChg>
    </pc:docChg>
  </pc:docChgLst>
  <pc:docChgLst>
    <pc:chgData name="Tanaka, Ryohei(田中　遼平)" userId="S::tanaka.ryohei@otsuka.jp::d3759886-a541-4f67-8e7e-2c1a5c833e51" providerId="AD" clId="Web-{E5F23DA0-B7EF-0824-967C-5E053D4C2EA5}"/>
    <pc:docChg chg="modSld">
      <pc:chgData name="Tanaka, Ryohei(田中　遼平)" userId="S::tanaka.ryohei@otsuka.jp::d3759886-a541-4f67-8e7e-2c1a5c833e51" providerId="AD" clId="Web-{E5F23DA0-B7EF-0824-967C-5E053D4C2EA5}" dt="2024-05-08T23:48:46.318" v="1" actId="20577"/>
      <pc:docMkLst>
        <pc:docMk/>
      </pc:docMkLst>
      <pc:sldChg chg="modSp">
        <pc:chgData name="Tanaka, Ryohei(田中　遼平)" userId="S::tanaka.ryohei@otsuka.jp::d3759886-a541-4f67-8e7e-2c1a5c833e51" providerId="AD" clId="Web-{E5F23DA0-B7EF-0824-967C-5E053D4C2EA5}" dt="2024-05-08T23:48:46.318" v="1" actId="20577"/>
        <pc:sldMkLst>
          <pc:docMk/>
          <pc:sldMk cId="430419261" sldId="277"/>
        </pc:sldMkLst>
        <pc:spChg chg="mod">
          <ac:chgData name="Tanaka, Ryohei(田中　遼平)" userId="S::tanaka.ryohei@otsuka.jp::d3759886-a541-4f67-8e7e-2c1a5c833e51" providerId="AD" clId="Web-{E5F23DA0-B7EF-0824-967C-5E053D4C2EA5}" dt="2024-05-08T23:48:46.318" v="1" actId="20577"/>
          <ac:spMkLst>
            <pc:docMk/>
            <pc:sldMk cId="430419261" sldId="277"/>
            <ac:spMk id="2" creationId="{42BA21FA-EF09-37F2-41C1-2CFD787E771D}"/>
          </ac:spMkLst>
        </pc:spChg>
      </pc:sldChg>
    </pc:docChg>
  </pc:docChgLst>
  <pc:docChgLst>
    <pc:chgData name="Joshi, Renu" userId="S::renu.joshi@otsuka-oph.com::834bd94a-69d6-44cb-9a70-3886341f17de" providerId="AD" clId="Web-{EF907CC1-2AB7-B8E0-C297-4C4E9307C0B5}"/>
    <pc:docChg chg="modSld">
      <pc:chgData name="Joshi, Renu" userId="S::renu.joshi@otsuka-oph.com::834bd94a-69d6-44cb-9a70-3886341f17de" providerId="AD" clId="Web-{EF907CC1-2AB7-B8E0-C297-4C4E9307C0B5}" dt="2024-04-29T18:12:10.394" v="3" actId="20577"/>
      <pc:docMkLst>
        <pc:docMk/>
      </pc:docMkLst>
      <pc:sldChg chg="modSp">
        <pc:chgData name="Joshi, Renu" userId="S::renu.joshi@otsuka-oph.com::834bd94a-69d6-44cb-9a70-3886341f17de" providerId="AD" clId="Web-{EF907CC1-2AB7-B8E0-C297-4C4E9307C0B5}" dt="2024-04-29T18:12:10.394" v="3" actId="20577"/>
        <pc:sldMkLst>
          <pc:docMk/>
          <pc:sldMk cId="2201129406" sldId="256"/>
        </pc:sldMkLst>
        <pc:spChg chg="mod">
          <ac:chgData name="Joshi, Renu" userId="S::renu.joshi@otsuka-oph.com::834bd94a-69d6-44cb-9a70-3886341f17de" providerId="AD" clId="Web-{EF907CC1-2AB7-B8E0-C297-4C4E9307C0B5}" dt="2024-04-29T18:12:10.394" v="3" actId="20577"/>
          <ac:spMkLst>
            <pc:docMk/>
            <pc:sldMk cId="2201129406" sldId="256"/>
            <ac:spMk id="4" creationId="{0BFA8ADE-3192-45C5-7E06-FD2A6C966662}"/>
          </ac:spMkLst>
        </pc:spChg>
      </pc:sldChg>
    </pc:docChg>
  </pc:docChgLst>
  <pc:docChgLst>
    <pc:chgData name="Zaidi, Sadia" userId="145bb054-69df-4ca4-bbf9-5b2a9f131ead" providerId="ADAL" clId="{25169489-75FA-0D4F-B3E6-5AA04D7B9810}"/>
    <pc:docChg chg="undo custSel addSld delSld modSld sldOrd">
      <pc:chgData name="Zaidi, Sadia" userId="145bb054-69df-4ca4-bbf9-5b2a9f131ead" providerId="ADAL" clId="{25169489-75FA-0D4F-B3E6-5AA04D7B9810}" dt="2024-04-16T16:26:49.556" v="2602" actId="20577"/>
      <pc:docMkLst>
        <pc:docMk/>
      </pc:docMkLst>
      <pc:sldChg chg="modSp mod">
        <pc:chgData name="Zaidi, Sadia" userId="145bb054-69df-4ca4-bbf9-5b2a9f131ead" providerId="ADAL" clId="{25169489-75FA-0D4F-B3E6-5AA04D7B9810}" dt="2024-04-15T18:28:27.836" v="2437" actId="20577"/>
        <pc:sldMkLst>
          <pc:docMk/>
          <pc:sldMk cId="2201129406" sldId="256"/>
        </pc:sldMkLst>
        <pc:spChg chg="mod">
          <ac:chgData name="Zaidi, Sadia" userId="145bb054-69df-4ca4-bbf9-5b2a9f131ead" providerId="ADAL" clId="{25169489-75FA-0D4F-B3E6-5AA04D7B9810}" dt="2024-04-15T18:28:27.836" v="2437" actId="20577"/>
          <ac:spMkLst>
            <pc:docMk/>
            <pc:sldMk cId="2201129406" sldId="256"/>
            <ac:spMk id="3" creationId="{252A1690-D753-E080-63E4-5246465B9D03}"/>
          </ac:spMkLst>
        </pc:spChg>
      </pc:sldChg>
      <pc:sldChg chg="addSp modSp mod">
        <pc:chgData name="Zaidi, Sadia" userId="145bb054-69df-4ca4-bbf9-5b2a9f131ead" providerId="ADAL" clId="{25169489-75FA-0D4F-B3E6-5AA04D7B9810}" dt="2024-04-12T17:13:08.638" v="1" actId="207"/>
        <pc:sldMkLst>
          <pc:docMk/>
          <pc:sldMk cId="2790155969" sldId="258"/>
        </pc:sldMkLst>
        <pc:spChg chg="add mod">
          <ac:chgData name="Zaidi, Sadia" userId="145bb054-69df-4ca4-bbf9-5b2a9f131ead" providerId="ADAL" clId="{25169489-75FA-0D4F-B3E6-5AA04D7B9810}" dt="2024-04-12T17:13:08.638" v="1" actId="207"/>
          <ac:spMkLst>
            <pc:docMk/>
            <pc:sldMk cId="2790155969" sldId="258"/>
            <ac:spMk id="2" creationId="{9F54936C-054F-7427-521D-9DD9DE33DFCF}"/>
          </ac:spMkLst>
        </pc:spChg>
      </pc:sldChg>
      <pc:sldChg chg="addSp modSp mod">
        <pc:chgData name="Zaidi, Sadia" userId="145bb054-69df-4ca4-bbf9-5b2a9f131ead" providerId="ADAL" clId="{25169489-75FA-0D4F-B3E6-5AA04D7B9810}" dt="2024-04-12T17:13:43.300" v="4" actId="1076"/>
        <pc:sldMkLst>
          <pc:docMk/>
          <pc:sldMk cId="512149448" sldId="259"/>
        </pc:sldMkLst>
        <pc:spChg chg="add mod">
          <ac:chgData name="Zaidi, Sadia" userId="145bb054-69df-4ca4-bbf9-5b2a9f131ead" providerId="ADAL" clId="{25169489-75FA-0D4F-B3E6-5AA04D7B9810}" dt="2024-04-12T17:13:43.300" v="4" actId="1076"/>
          <ac:spMkLst>
            <pc:docMk/>
            <pc:sldMk cId="512149448" sldId="259"/>
            <ac:spMk id="2" creationId="{6625E276-01A8-8640-E95D-B5BEBC866F66}"/>
          </ac:spMkLst>
        </pc:spChg>
      </pc:sldChg>
      <pc:sldChg chg="addSp modSp mod">
        <pc:chgData name="Zaidi, Sadia" userId="145bb054-69df-4ca4-bbf9-5b2a9f131ead" providerId="ADAL" clId="{25169489-75FA-0D4F-B3E6-5AA04D7B9810}" dt="2024-04-12T17:14:28.916" v="7" actId="1076"/>
        <pc:sldMkLst>
          <pc:docMk/>
          <pc:sldMk cId="2071285396" sldId="260"/>
        </pc:sldMkLst>
        <pc:spChg chg="add mod">
          <ac:chgData name="Zaidi, Sadia" userId="145bb054-69df-4ca4-bbf9-5b2a9f131ead" providerId="ADAL" clId="{25169489-75FA-0D4F-B3E6-5AA04D7B9810}" dt="2024-04-12T17:14:28.916" v="7" actId="1076"/>
          <ac:spMkLst>
            <pc:docMk/>
            <pc:sldMk cId="2071285396" sldId="260"/>
            <ac:spMk id="3" creationId="{D0FA77FD-2085-1F00-1D7C-4AFAC111D822}"/>
          </ac:spMkLst>
        </pc:spChg>
      </pc:sldChg>
      <pc:sldChg chg="addSp modSp mod">
        <pc:chgData name="Zaidi, Sadia" userId="145bb054-69df-4ca4-bbf9-5b2a9f131ead" providerId="ADAL" clId="{25169489-75FA-0D4F-B3E6-5AA04D7B9810}" dt="2024-04-12T17:15:14.113" v="13" actId="1076"/>
        <pc:sldMkLst>
          <pc:docMk/>
          <pc:sldMk cId="624350079" sldId="264"/>
        </pc:sldMkLst>
        <pc:spChg chg="add mod">
          <ac:chgData name="Zaidi, Sadia" userId="145bb054-69df-4ca4-bbf9-5b2a9f131ead" providerId="ADAL" clId="{25169489-75FA-0D4F-B3E6-5AA04D7B9810}" dt="2024-04-12T17:15:14.113" v="13" actId="1076"/>
          <ac:spMkLst>
            <pc:docMk/>
            <pc:sldMk cId="624350079" sldId="264"/>
            <ac:spMk id="9" creationId="{FBC68926-412C-58F7-AA3A-7414334F03B7}"/>
          </ac:spMkLst>
        </pc:spChg>
      </pc:sldChg>
      <pc:sldChg chg="addSp modSp mod">
        <pc:chgData name="Zaidi, Sadia" userId="145bb054-69df-4ca4-bbf9-5b2a9f131ead" providerId="ADAL" clId="{25169489-75FA-0D4F-B3E6-5AA04D7B9810}" dt="2024-04-12T17:16:01.383" v="15" actId="1076"/>
        <pc:sldMkLst>
          <pc:docMk/>
          <pc:sldMk cId="4053584341" sldId="266"/>
        </pc:sldMkLst>
        <pc:spChg chg="add mod">
          <ac:chgData name="Zaidi, Sadia" userId="145bb054-69df-4ca4-bbf9-5b2a9f131ead" providerId="ADAL" clId="{25169489-75FA-0D4F-B3E6-5AA04D7B9810}" dt="2024-04-12T17:16:01.383" v="15" actId="1076"/>
          <ac:spMkLst>
            <pc:docMk/>
            <pc:sldMk cId="4053584341" sldId="266"/>
            <ac:spMk id="3" creationId="{36B1CC07-A643-F875-0274-D63AA5D1190E}"/>
          </ac:spMkLst>
        </pc:spChg>
      </pc:sldChg>
      <pc:sldChg chg="addSp modSp mod">
        <pc:chgData name="Zaidi, Sadia" userId="145bb054-69df-4ca4-bbf9-5b2a9f131ead" providerId="ADAL" clId="{25169489-75FA-0D4F-B3E6-5AA04D7B9810}" dt="2024-04-12T17:14:52.649" v="11" actId="1076"/>
        <pc:sldMkLst>
          <pc:docMk/>
          <pc:sldMk cId="3597123633" sldId="271"/>
        </pc:sldMkLst>
        <pc:spChg chg="add mod">
          <ac:chgData name="Zaidi, Sadia" userId="145bb054-69df-4ca4-bbf9-5b2a9f131ead" providerId="ADAL" clId="{25169489-75FA-0D4F-B3E6-5AA04D7B9810}" dt="2024-04-12T17:14:47.413" v="9" actId="1076"/>
          <ac:spMkLst>
            <pc:docMk/>
            <pc:sldMk cId="3597123633" sldId="271"/>
            <ac:spMk id="2" creationId="{BEA5575F-4349-1A91-7D07-75F892A30E0E}"/>
          </ac:spMkLst>
        </pc:spChg>
        <pc:spChg chg="add mod">
          <ac:chgData name="Zaidi, Sadia" userId="145bb054-69df-4ca4-bbf9-5b2a9f131ead" providerId="ADAL" clId="{25169489-75FA-0D4F-B3E6-5AA04D7B9810}" dt="2024-04-12T17:14:52.649" v="11" actId="1076"/>
          <ac:spMkLst>
            <pc:docMk/>
            <pc:sldMk cId="3597123633" sldId="271"/>
            <ac:spMk id="3" creationId="{065651B6-4A44-48B7-F39A-3F056D371B99}"/>
          </ac:spMkLst>
        </pc:spChg>
      </pc:sldChg>
      <pc:sldChg chg="new del ord">
        <pc:chgData name="Zaidi, Sadia" userId="145bb054-69df-4ca4-bbf9-5b2a9f131ead" providerId="ADAL" clId="{25169489-75FA-0D4F-B3E6-5AA04D7B9810}" dt="2024-04-12T17:22:11.307" v="20" actId="2696"/>
        <pc:sldMkLst>
          <pc:docMk/>
          <pc:sldMk cId="1543713199" sldId="273"/>
        </pc:sldMkLst>
      </pc:sldChg>
      <pc:sldChg chg="addSp delSp modSp add mod ord">
        <pc:chgData name="Zaidi, Sadia" userId="145bb054-69df-4ca4-bbf9-5b2a9f131ead" providerId="ADAL" clId="{25169489-75FA-0D4F-B3E6-5AA04D7B9810}" dt="2024-04-15T18:38:50.404" v="2558" actId="1076"/>
        <pc:sldMkLst>
          <pc:docMk/>
          <pc:sldMk cId="2222494559" sldId="274"/>
        </pc:sldMkLst>
        <pc:spChg chg="mod">
          <ac:chgData name="Zaidi, Sadia" userId="145bb054-69df-4ca4-bbf9-5b2a9f131ead" providerId="ADAL" clId="{25169489-75FA-0D4F-B3E6-5AA04D7B9810}" dt="2024-04-15T18:38:50.404" v="2558" actId="1076"/>
          <ac:spMkLst>
            <pc:docMk/>
            <pc:sldMk cId="2222494559" sldId="274"/>
            <ac:spMk id="2" creationId="{B89276B1-CD70-230A-B22D-C498614C64D9}"/>
          </ac:spMkLst>
        </pc:spChg>
        <pc:spChg chg="add del mod">
          <ac:chgData name="Zaidi, Sadia" userId="145bb054-69df-4ca4-bbf9-5b2a9f131ead" providerId="ADAL" clId="{25169489-75FA-0D4F-B3E6-5AA04D7B9810}" dt="2024-04-12T17:23:30.774" v="84" actId="478"/>
          <ac:spMkLst>
            <pc:docMk/>
            <pc:sldMk cId="2222494559" sldId="274"/>
            <ac:spMk id="4" creationId="{15114C32-BCC1-20FA-5C36-17CFDB42A9CE}"/>
          </ac:spMkLst>
        </pc:spChg>
        <pc:spChg chg="mod">
          <ac:chgData name="Zaidi, Sadia" userId="145bb054-69df-4ca4-bbf9-5b2a9f131ead" providerId="ADAL" clId="{25169489-75FA-0D4F-B3E6-5AA04D7B9810}" dt="2024-04-12T17:26:56.773" v="291"/>
          <ac:spMkLst>
            <pc:docMk/>
            <pc:sldMk cId="2222494559" sldId="274"/>
            <ac:spMk id="13" creationId="{C0DE2699-4CDB-9925-8114-90445A6AE8CF}"/>
          </ac:spMkLst>
        </pc:spChg>
        <pc:spChg chg="mod">
          <ac:chgData name="Zaidi, Sadia" userId="145bb054-69df-4ca4-bbf9-5b2a9f131ead" providerId="ADAL" clId="{25169489-75FA-0D4F-B3E6-5AA04D7B9810}" dt="2024-04-12T17:30:41.359" v="308"/>
          <ac:spMkLst>
            <pc:docMk/>
            <pc:sldMk cId="2222494559" sldId="274"/>
            <ac:spMk id="21" creationId="{5C59BDE4-E3DD-CBE6-415C-CC1A0A6ACAE3}"/>
          </ac:spMkLst>
        </pc:spChg>
        <pc:spChg chg="add mod">
          <ac:chgData name="Zaidi, Sadia" userId="145bb054-69df-4ca4-bbf9-5b2a9f131ead" providerId="ADAL" clId="{25169489-75FA-0D4F-B3E6-5AA04D7B9810}" dt="2024-04-15T18:36:52.105" v="2523" actId="20577"/>
          <ac:spMkLst>
            <pc:docMk/>
            <pc:sldMk cId="2222494559" sldId="274"/>
            <ac:spMk id="24" creationId="{B1A1BFE8-1A2A-58FD-D67D-8EAB58A7B364}"/>
          </ac:spMkLst>
        </pc:spChg>
        <pc:spChg chg="add mod">
          <ac:chgData name="Zaidi, Sadia" userId="145bb054-69df-4ca4-bbf9-5b2a9f131ead" providerId="ADAL" clId="{25169489-75FA-0D4F-B3E6-5AA04D7B9810}" dt="2024-04-15T18:37:28.753" v="2531" actId="20577"/>
          <ac:spMkLst>
            <pc:docMk/>
            <pc:sldMk cId="2222494559" sldId="274"/>
            <ac:spMk id="25" creationId="{8444DA4E-CB29-261D-BBB8-4C6631F20122}"/>
          </ac:spMkLst>
        </pc:spChg>
        <pc:spChg chg="add mod">
          <ac:chgData name="Zaidi, Sadia" userId="145bb054-69df-4ca4-bbf9-5b2a9f131ead" providerId="ADAL" clId="{25169489-75FA-0D4F-B3E6-5AA04D7B9810}" dt="2024-04-15T18:37:31.788" v="2533" actId="20577"/>
          <ac:spMkLst>
            <pc:docMk/>
            <pc:sldMk cId="2222494559" sldId="274"/>
            <ac:spMk id="26" creationId="{D1B855C3-F55D-32CC-59AD-4D821999C7E7}"/>
          </ac:spMkLst>
        </pc:spChg>
        <pc:grpChg chg="add del mod">
          <ac:chgData name="Zaidi, Sadia" userId="145bb054-69df-4ca4-bbf9-5b2a9f131ead" providerId="ADAL" clId="{25169489-75FA-0D4F-B3E6-5AA04D7B9810}" dt="2024-04-15T17:44:52.092" v="1145" actId="478"/>
          <ac:grpSpMkLst>
            <pc:docMk/>
            <pc:sldMk cId="2222494559" sldId="274"/>
            <ac:grpSpMk id="10" creationId="{3E3A676B-34FA-929A-7211-64BD1C8C91E5}"/>
          </ac:grpSpMkLst>
        </pc:grpChg>
        <pc:grpChg chg="add del mod">
          <ac:chgData name="Zaidi, Sadia" userId="145bb054-69df-4ca4-bbf9-5b2a9f131ead" providerId="ADAL" clId="{25169489-75FA-0D4F-B3E6-5AA04D7B9810}" dt="2024-04-15T17:52:37.862" v="1398" actId="478"/>
          <ac:grpSpMkLst>
            <pc:docMk/>
            <pc:sldMk cId="2222494559" sldId="274"/>
            <ac:grpSpMk id="19" creationId="{A5EF41C3-A688-DE4B-AE91-DBD1C9CDFA5D}"/>
          </ac:grpSpMkLst>
        </pc:grpChg>
        <pc:graphicFrameChg chg="del modGraphic">
          <ac:chgData name="Zaidi, Sadia" userId="145bb054-69df-4ca4-bbf9-5b2a9f131ead" providerId="ADAL" clId="{25169489-75FA-0D4F-B3E6-5AA04D7B9810}" dt="2024-04-12T17:23:27.993" v="83" actId="478"/>
          <ac:graphicFrameMkLst>
            <pc:docMk/>
            <pc:sldMk cId="2222494559" sldId="274"/>
            <ac:graphicFrameMk id="5" creationId="{2F0BFDC6-2B5C-1804-A91E-551C62FA687D}"/>
          </ac:graphicFrameMkLst>
        </pc:graphicFrameChg>
        <pc:picChg chg="del">
          <ac:chgData name="Zaidi, Sadia" userId="145bb054-69df-4ca4-bbf9-5b2a9f131ead" providerId="ADAL" clId="{25169489-75FA-0D4F-B3E6-5AA04D7B9810}" dt="2024-04-12T17:23:34.643" v="85" actId="478"/>
          <ac:picMkLst>
            <pc:docMk/>
            <pc:sldMk cId="2222494559" sldId="274"/>
            <ac:picMk id="6" creationId="{A1D0636E-4411-C74F-2572-F81B36FC592E}"/>
          </ac:picMkLst>
        </pc:picChg>
        <pc:picChg chg="del">
          <ac:chgData name="Zaidi, Sadia" userId="145bb054-69df-4ca4-bbf9-5b2a9f131ead" providerId="ADAL" clId="{25169489-75FA-0D4F-B3E6-5AA04D7B9810}" dt="2024-04-12T17:23:34.643" v="85" actId="478"/>
          <ac:picMkLst>
            <pc:docMk/>
            <pc:sldMk cId="2222494559" sldId="274"/>
            <ac:picMk id="7" creationId="{4366275F-F076-896B-270D-3E74032D73C4}"/>
          </ac:picMkLst>
        </pc:picChg>
        <pc:picChg chg="del">
          <ac:chgData name="Zaidi, Sadia" userId="145bb054-69df-4ca4-bbf9-5b2a9f131ead" providerId="ADAL" clId="{25169489-75FA-0D4F-B3E6-5AA04D7B9810}" dt="2024-04-12T17:23:34.643" v="85" actId="478"/>
          <ac:picMkLst>
            <pc:docMk/>
            <pc:sldMk cId="2222494559" sldId="274"/>
            <ac:picMk id="8" creationId="{4308F717-09BF-0451-6931-C7C6C21DB957}"/>
          </ac:picMkLst>
        </pc:picChg>
        <pc:picChg chg="add mod">
          <ac:chgData name="Zaidi, Sadia" userId="145bb054-69df-4ca4-bbf9-5b2a9f131ead" providerId="ADAL" clId="{25169489-75FA-0D4F-B3E6-5AA04D7B9810}" dt="2024-04-15T18:32:04.597" v="2463" actId="1035"/>
          <ac:picMkLst>
            <pc:docMk/>
            <pc:sldMk cId="2222494559" sldId="274"/>
            <ac:picMk id="9" creationId="{66428C27-3F50-9859-D2D4-87AC7E0FE194}"/>
          </ac:picMkLst>
        </pc:picChg>
        <pc:picChg chg="mod">
          <ac:chgData name="Zaidi, Sadia" userId="145bb054-69df-4ca4-bbf9-5b2a9f131ead" providerId="ADAL" clId="{25169489-75FA-0D4F-B3E6-5AA04D7B9810}" dt="2024-04-12T17:26:56.773" v="291"/>
          <ac:picMkLst>
            <pc:docMk/>
            <pc:sldMk cId="2222494559" sldId="274"/>
            <ac:picMk id="11" creationId="{904BD88F-28E7-0949-D33D-A034EE4A27DE}"/>
          </ac:picMkLst>
        </pc:picChg>
        <pc:picChg chg="add mod">
          <ac:chgData name="Zaidi, Sadia" userId="145bb054-69df-4ca4-bbf9-5b2a9f131ead" providerId="ADAL" clId="{25169489-75FA-0D4F-B3E6-5AA04D7B9810}" dt="2024-04-15T18:32:04.597" v="2463" actId="1035"/>
          <ac:picMkLst>
            <pc:docMk/>
            <pc:sldMk cId="2222494559" sldId="274"/>
            <ac:picMk id="16" creationId="{AE4B9BCE-3E4D-2366-895C-A69BDE232695}"/>
          </ac:picMkLst>
        </pc:picChg>
        <pc:picChg chg="add mod">
          <ac:chgData name="Zaidi, Sadia" userId="145bb054-69df-4ca4-bbf9-5b2a9f131ead" providerId="ADAL" clId="{25169489-75FA-0D4F-B3E6-5AA04D7B9810}" dt="2024-04-15T18:32:04.597" v="2463" actId="1035"/>
          <ac:picMkLst>
            <pc:docMk/>
            <pc:sldMk cId="2222494559" sldId="274"/>
            <ac:picMk id="17" creationId="{700667C0-AF05-20E4-9489-6B0AB26A3941}"/>
          </ac:picMkLst>
        </pc:picChg>
        <pc:picChg chg="add del mod">
          <ac:chgData name="Zaidi, Sadia" userId="145bb054-69df-4ca4-bbf9-5b2a9f131ead" providerId="ADAL" clId="{25169489-75FA-0D4F-B3E6-5AA04D7B9810}" dt="2024-04-12T17:30:39.104" v="307" actId="478"/>
          <ac:picMkLst>
            <pc:docMk/>
            <pc:sldMk cId="2222494559" sldId="274"/>
            <ac:picMk id="18" creationId="{6C9DEE64-8BF2-824B-7631-5BD03FD4F2F1}"/>
          </ac:picMkLst>
        </pc:picChg>
        <pc:picChg chg="mod">
          <ac:chgData name="Zaidi, Sadia" userId="145bb054-69df-4ca4-bbf9-5b2a9f131ead" providerId="ADAL" clId="{25169489-75FA-0D4F-B3E6-5AA04D7B9810}" dt="2024-04-12T17:30:41.359" v="308"/>
          <ac:picMkLst>
            <pc:docMk/>
            <pc:sldMk cId="2222494559" sldId="274"/>
            <ac:picMk id="20" creationId="{F5BBD8E6-2277-0A8E-058D-4B6A1176BA63}"/>
          </ac:picMkLst>
        </pc:picChg>
        <pc:cxnChg chg="del">
          <ac:chgData name="Zaidi, Sadia" userId="145bb054-69df-4ca4-bbf9-5b2a9f131ead" providerId="ADAL" clId="{25169489-75FA-0D4F-B3E6-5AA04D7B9810}" dt="2024-04-12T17:23:34.643" v="85" actId="478"/>
          <ac:cxnSpMkLst>
            <pc:docMk/>
            <pc:sldMk cId="2222494559" sldId="274"/>
            <ac:cxnSpMk id="14" creationId="{81825689-AA50-96F6-B392-7B383405F124}"/>
          </ac:cxnSpMkLst>
        </pc:cxnChg>
        <pc:cxnChg chg="del">
          <ac:chgData name="Zaidi, Sadia" userId="145bb054-69df-4ca4-bbf9-5b2a9f131ead" providerId="ADAL" clId="{25169489-75FA-0D4F-B3E6-5AA04D7B9810}" dt="2024-04-12T17:23:34.643" v="85" actId="478"/>
          <ac:cxnSpMkLst>
            <pc:docMk/>
            <pc:sldMk cId="2222494559" sldId="274"/>
            <ac:cxnSpMk id="15" creationId="{98216028-2DAB-5CB3-88C7-1AE9992A059C}"/>
          </ac:cxnSpMkLst>
        </pc:cxnChg>
        <pc:cxnChg chg="mod">
          <ac:chgData name="Zaidi, Sadia" userId="145bb054-69df-4ca4-bbf9-5b2a9f131ead" providerId="ADAL" clId="{25169489-75FA-0D4F-B3E6-5AA04D7B9810}" dt="2024-04-12T17:30:41.359" v="308"/>
          <ac:cxnSpMkLst>
            <pc:docMk/>
            <pc:sldMk cId="2222494559" sldId="274"/>
            <ac:cxnSpMk id="22" creationId="{2CFD9768-81FE-5C26-9FD3-A00FFCF2784E}"/>
          </ac:cxnSpMkLst>
        </pc:cxnChg>
      </pc:sldChg>
      <pc:sldChg chg="new">
        <pc:chgData name="Zaidi, Sadia" userId="145bb054-69df-4ca4-bbf9-5b2a9f131ead" providerId="ADAL" clId="{25169489-75FA-0D4F-B3E6-5AA04D7B9810}" dt="2024-04-12T17:22:19.335" v="21" actId="680"/>
        <pc:sldMkLst>
          <pc:docMk/>
          <pc:sldMk cId="2967016943" sldId="275"/>
        </pc:sldMkLst>
      </pc:sldChg>
      <pc:sldChg chg="addSp delSp modSp add mod ord">
        <pc:chgData name="Zaidi, Sadia" userId="145bb054-69df-4ca4-bbf9-5b2a9f131ead" providerId="ADAL" clId="{25169489-75FA-0D4F-B3E6-5AA04D7B9810}" dt="2024-04-16T16:26:49.556" v="2602" actId="20577"/>
        <pc:sldMkLst>
          <pc:docMk/>
          <pc:sldMk cId="430419261" sldId="276"/>
        </pc:sldMkLst>
        <pc:spChg chg="mod">
          <ac:chgData name="Zaidi, Sadia" userId="145bb054-69df-4ca4-bbf9-5b2a9f131ead" providerId="ADAL" clId="{25169489-75FA-0D4F-B3E6-5AA04D7B9810}" dt="2024-04-16T16:26:49.556" v="2602" actId="20577"/>
          <ac:spMkLst>
            <pc:docMk/>
            <pc:sldMk cId="430419261" sldId="276"/>
            <ac:spMk id="2" creationId="{42BA21FA-EF09-37F2-41C1-2CFD787E771D}"/>
          </ac:spMkLst>
        </pc:spChg>
        <pc:spChg chg="mod">
          <ac:chgData name="Zaidi, Sadia" userId="145bb054-69df-4ca4-bbf9-5b2a9f131ead" providerId="ADAL" clId="{25169489-75FA-0D4F-B3E6-5AA04D7B9810}" dt="2024-04-15T18:35:53.859" v="2502" actId="20577"/>
          <ac:spMkLst>
            <pc:docMk/>
            <pc:sldMk cId="430419261" sldId="276"/>
            <ac:spMk id="3" creationId="{C22FDA56-5E71-F99C-DC9B-15F3491CF4A2}"/>
          </ac:spMkLst>
        </pc:spChg>
        <pc:spChg chg="del mod">
          <ac:chgData name="Zaidi, Sadia" userId="145bb054-69df-4ca4-bbf9-5b2a9f131ead" providerId="ADAL" clId="{25169489-75FA-0D4F-B3E6-5AA04D7B9810}" dt="2024-04-15T17:56:27.286" v="1586" actId="478"/>
          <ac:spMkLst>
            <pc:docMk/>
            <pc:sldMk cId="430419261" sldId="276"/>
            <ac:spMk id="9" creationId="{FBC68926-412C-58F7-AA3A-7414334F03B7}"/>
          </ac:spMkLst>
        </pc:spChg>
        <pc:spChg chg="mod">
          <ac:chgData name="Zaidi, Sadia" userId="145bb054-69df-4ca4-bbf9-5b2a9f131ead" providerId="ADAL" clId="{25169489-75FA-0D4F-B3E6-5AA04D7B9810}" dt="2024-04-15T18:36:12.901" v="2518" actId="122"/>
          <ac:spMkLst>
            <pc:docMk/>
            <pc:sldMk cId="430419261" sldId="276"/>
            <ac:spMk id="11" creationId="{D2143986-AE7C-1B78-A2BA-45F229799339}"/>
          </ac:spMkLst>
        </pc:spChg>
        <pc:spChg chg="mod">
          <ac:chgData name="Zaidi, Sadia" userId="145bb054-69df-4ca4-bbf9-5b2a9f131ead" providerId="ADAL" clId="{25169489-75FA-0D4F-B3E6-5AA04D7B9810}" dt="2024-04-15T18:34:44.650" v="2474" actId="255"/>
          <ac:spMkLst>
            <pc:docMk/>
            <pc:sldMk cId="430419261" sldId="276"/>
            <ac:spMk id="12" creationId="{033F9AE3-43C5-3DF2-221E-AA962CE80191}"/>
          </ac:spMkLst>
        </pc:spChg>
        <pc:spChg chg="add del mod">
          <ac:chgData name="Zaidi, Sadia" userId="145bb054-69df-4ca4-bbf9-5b2a9f131ead" providerId="ADAL" clId="{25169489-75FA-0D4F-B3E6-5AA04D7B9810}" dt="2024-04-15T17:54:46.349" v="1503" actId="478"/>
          <ac:spMkLst>
            <pc:docMk/>
            <pc:sldMk cId="430419261" sldId="276"/>
            <ac:spMk id="14" creationId="{5E838388-FFDA-DE67-DB5B-28F33CB6FF6C}"/>
          </ac:spMkLst>
        </pc:spChg>
        <pc:spChg chg="add mod">
          <ac:chgData name="Zaidi, Sadia" userId="145bb054-69df-4ca4-bbf9-5b2a9f131ead" providerId="ADAL" clId="{25169489-75FA-0D4F-B3E6-5AA04D7B9810}" dt="2024-04-15T18:37:53.903" v="2538" actId="20577"/>
          <ac:spMkLst>
            <pc:docMk/>
            <pc:sldMk cId="430419261" sldId="276"/>
            <ac:spMk id="17" creationId="{AFD94C4B-036E-BF18-5DA9-60B39794D29A}"/>
          </ac:spMkLst>
        </pc:spChg>
        <pc:spChg chg="mod">
          <ac:chgData name="Zaidi, Sadia" userId="145bb054-69df-4ca4-bbf9-5b2a9f131ead" providerId="ADAL" clId="{25169489-75FA-0D4F-B3E6-5AA04D7B9810}" dt="2024-04-15T18:20:16.490" v="2202" actId="165"/>
          <ac:spMkLst>
            <pc:docMk/>
            <pc:sldMk cId="430419261" sldId="276"/>
            <ac:spMk id="20" creationId="{F007A05E-F4D2-B9AE-B625-3837D8EE666A}"/>
          </ac:spMkLst>
        </pc:spChg>
        <pc:spChg chg="add mod">
          <ac:chgData name="Zaidi, Sadia" userId="145bb054-69df-4ca4-bbf9-5b2a9f131ead" providerId="ADAL" clId="{25169489-75FA-0D4F-B3E6-5AA04D7B9810}" dt="2024-04-15T18:24:12.156" v="2308" actId="1035"/>
          <ac:spMkLst>
            <pc:docMk/>
            <pc:sldMk cId="430419261" sldId="276"/>
            <ac:spMk id="22" creationId="{0B663273-4B52-2ADB-B1C3-79CA40E4D9CB}"/>
          </ac:spMkLst>
        </pc:spChg>
        <pc:spChg chg="mod">
          <ac:chgData name="Zaidi, Sadia" userId="145bb054-69df-4ca4-bbf9-5b2a9f131ead" providerId="ADAL" clId="{25169489-75FA-0D4F-B3E6-5AA04D7B9810}" dt="2024-04-15T18:34:09.874" v="2470" actId="408"/>
          <ac:spMkLst>
            <pc:docMk/>
            <pc:sldMk cId="430419261" sldId="276"/>
            <ac:spMk id="23" creationId="{17E5F9B0-89C1-DC72-D958-25F38B67156D}"/>
          </ac:spMkLst>
        </pc:spChg>
        <pc:spChg chg="mod">
          <ac:chgData name="Zaidi, Sadia" userId="145bb054-69df-4ca4-bbf9-5b2a9f131ead" providerId="ADAL" clId="{25169489-75FA-0D4F-B3E6-5AA04D7B9810}" dt="2024-04-15T18:34:09.874" v="2470" actId="408"/>
          <ac:spMkLst>
            <pc:docMk/>
            <pc:sldMk cId="430419261" sldId="276"/>
            <ac:spMk id="27" creationId="{21FCEA5E-EDEE-18FC-73DE-B54C01C9C17A}"/>
          </ac:spMkLst>
        </pc:spChg>
        <pc:spChg chg="mod">
          <ac:chgData name="Zaidi, Sadia" userId="145bb054-69df-4ca4-bbf9-5b2a9f131ead" providerId="ADAL" clId="{25169489-75FA-0D4F-B3E6-5AA04D7B9810}" dt="2024-04-15T18:34:09.874" v="2470" actId="408"/>
          <ac:spMkLst>
            <pc:docMk/>
            <pc:sldMk cId="430419261" sldId="276"/>
            <ac:spMk id="28" creationId="{2A1D7F85-AF8F-22F2-70D1-C48A37874B7D}"/>
          </ac:spMkLst>
        </pc:spChg>
        <pc:spChg chg="mod topLvl">
          <ac:chgData name="Zaidi, Sadia" userId="145bb054-69df-4ca4-bbf9-5b2a9f131ead" providerId="ADAL" clId="{25169489-75FA-0D4F-B3E6-5AA04D7B9810}" dt="2024-04-15T18:20:34.304" v="2203" actId="338"/>
          <ac:spMkLst>
            <pc:docMk/>
            <pc:sldMk cId="430419261" sldId="276"/>
            <ac:spMk id="30" creationId="{4EC8C6A5-BACC-924B-C61A-FAB11C87AC5B}"/>
          </ac:spMkLst>
        </pc:spChg>
        <pc:grpChg chg="add mod">
          <ac:chgData name="Zaidi, Sadia" userId="145bb054-69df-4ca4-bbf9-5b2a9f131ead" providerId="ADAL" clId="{25169489-75FA-0D4F-B3E6-5AA04D7B9810}" dt="2024-04-15T18:34:09.874" v="2470" actId="408"/>
          <ac:grpSpMkLst>
            <pc:docMk/>
            <pc:sldMk cId="430419261" sldId="276"/>
            <ac:grpSpMk id="19" creationId="{B2E92C65-B03F-B809-5B59-2378283931D8}"/>
          </ac:grpSpMkLst>
        </pc:grpChg>
        <pc:grpChg chg="add del mod">
          <ac:chgData name="Zaidi, Sadia" userId="145bb054-69df-4ca4-bbf9-5b2a9f131ead" providerId="ADAL" clId="{25169489-75FA-0D4F-B3E6-5AA04D7B9810}" dt="2024-04-15T18:20:16.490" v="2202" actId="165"/>
          <ac:grpSpMkLst>
            <pc:docMk/>
            <pc:sldMk cId="430419261" sldId="276"/>
            <ac:grpSpMk id="24" creationId="{C87F83BE-F015-48E7-42B2-D1D14790EEB3}"/>
          </ac:grpSpMkLst>
        </pc:grpChg>
        <pc:grpChg chg="add mod">
          <ac:chgData name="Zaidi, Sadia" userId="145bb054-69df-4ca4-bbf9-5b2a9f131ead" providerId="ADAL" clId="{25169489-75FA-0D4F-B3E6-5AA04D7B9810}" dt="2024-04-15T18:34:09.874" v="2470" actId="408"/>
          <ac:grpSpMkLst>
            <pc:docMk/>
            <pc:sldMk cId="430419261" sldId="276"/>
            <ac:grpSpMk id="26" creationId="{477E199E-3E85-288D-EC55-E0206AFE6A78}"/>
          </ac:grpSpMkLst>
        </pc:grpChg>
        <pc:grpChg chg="del">
          <ac:chgData name="Zaidi, Sadia" userId="145bb054-69df-4ca4-bbf9-5b2a9f131ead" providerId="ADAL" clId="{25169489-75FA-0D4F-B3E6-5AA04D7B9810}" dt="2024-04-15T17:54:47.357" v="1504" actId="478"/>
          <ac:grpSpMkLst>
            <pc:docMk/>
            <pc:sldMk cId="430419261" sldId="276"/>
            <ac:grpSpMk id="32" creationId="{6F93C9B3-01DD-6D99-6927-7225B1F19165}"/>
          </ac:grpSpMkLst>
        </pc:grpChg>
        <pc:grpChg chg="mod topLvl">
          <ac:chgData name="Zaidi, Sadia" userId="145bb054-69df-4ca4-bbf9-5b2a9f131ead" providerId="ADAL" clId="{25169489-75FA-0D4F-B3E6-5AA04D7B9810}" dt="2024-04-15T18:20:34.304" v="2203" actId="338"/>
          <ac:grpSpMkLst>
            <pc:docMk/>
            <pc:sldMk cId="430419261" sldId="276"/>
            <ac:grpSpMk id="33" creationId="{EA271BFC-95DB-A719-6AEE-8C54763C75DB}"/>
          </ac:grpSpMkLst>
        </pc:grpChg>
        <pc:grpChg chg="mod">
          <ac:chgData name="Zaidi, Sadia" userId="145bb054-69df-4ca4-bbf9-5b2a9f131ead" providerId="ADAL" clId="{25169489-75FA-0D4F-B3E6-5AA04D7B9810}" dt="2024-04-15T18:34:09.874" v="2470" actId="408"/>
          <ac:grpSpMkLst>
            <pc:docMk/>
            <pc:sldMk cId="430419261" sldId="276"/>
            <ac:grpSpMk id="34" creationId="{6A809B0F-84F3-42DF-5186-EBB7C9709C0F}"/>
          </ac:grpSpMkLst>
        </pc:grpChg>
        <pc:grpChg chg="mod">
          <ac:chgData name="Zaidi, Sadia" userId="145bb054-69df-4ca4-bbf9-5b2a9f131ead" providerId="ADAL" clId="{25169489-75FA-0D4F-B3E6-5AA04D7B9810}" dt="2024-04-15T18:34:09.874" v="2470" actId="408"/>
          <ac:grpSpMkLst>
            <pc:docMk/>
            <pc:sldMk cId="430419261" sldId="276"/>
            <ac:grpSpMk id="35" creationId="{D72028B9-DB27-C6D2-7F67-ED9B1D8F756C}"/>
          </ac:grpSpMkLst>
        </pc:grpChg>
        <pc:graphicFrameChg chg="del">
          <ac:chgData name="Zaidi, Sadia" userId="145bb054-69df-4ca4-bbf9-5b2a9f131ead" providerId="ADAL" clId="{25169489-75FA-0D4F-B3E6-5AA04D7B9810}" dt="2024-04-15T17:54:44.304" v="1502" actId="478"/>
          <ac:graphicFrameMkLst>
            <pc:docMk/>
            <pc:sldMk cId="430419261" sldId="276"/>
            <ac:graphicFrameMk id="5" creationId="{D8992723-85E9-EE25-7107-4E9225930AAE}"/>
          </ac:graphicFrameMkLst>
        </pc:graphicFrameChg>
        <pc:picChg chg="mod">
          <ac:chgData name="Zaidi, Sadia" userId="145bb054-69df-4ca4-bbf9-5b2a9f131ead" providerId="ADAL" clId="{25169489-75FA-0D4F-B3E6-5AA04D7B9810}" dt="2024-04-15T18:34:09.874" v="2470" actId="408"/>
          <ac:picMkLst>
            <pc:docMk/>
            <pc:sldMk cId="430419261" sldId="276"/>
            <ac:picMk id="6" creationId="{1ED602B8-0F1B-563D-759D-DA4E0ADDB086}"/>
          </ac:picMkLst>
        </pc:picChg>
        <pc:picChg chg="mod">
          <ac:chgData name="Zaidi, Sadia" userId="145bb054-69df-4ca4-bbf9-5b2a9f131ead" providerId="ADAL" clId="{25169489-75FA-0D4F-B3E6-5AA04D7B9810}" dt="2024-04-15T18:34:09.874" v="2470" actId="408"/>
          <ac:picMkLst>
            <pc:docMk/>
            <pc:sldMk cId="430419261" sldId="276"/>
            <ac:picMk id="8" creationId="{C122189F-C76A-95BF-ACA1-4CE96D718080}"/>
          </ac:picMkLst>
        </pc:picChg>
        <pc:picChg chg="add mod">
          <ac:chgData name="Zaidi, Sadia" userId="145bb054-69df-4ca4-bbf9-5b2a9f131ead" providerId="ADAL" clId="{25169489-75FA-0D4F-B3E6-5AA04D7B9810}" dt="2024-04-15T18:34:09.874" v="2470" actId="408"/>
          <ac:picMkLst>
            <pc:docMk/>
            <pc:sldMk cId="430419261" sldId="276"/>
            <ac:picMk id="16" creationId="{D6F77575-8E59-F7CE-E9C5-67B53E95751D}"/>
          </ac:picMkLst>
        </pc:picChg>
        <pc:picChg chg="mod">
          <ac:chgData name="Zaidi, Sadia" userId="145bb054-69df-4ca4-bbf9-5b2a9f131ead" providerId="ADAL" clId="{25169489-75FA-0D4F-B3E6-5AA04D7B9810}" dt="2024-04-15T18:20:16.490" v="2202" actId="165"/>
          <ac:picMkLst>
            <pc:docMk/>
            <pc:sldMk cId="430419261" sldId="276"/>
            <ac:picMk id="18" creationId="{FCA7724E-2E02-8394-E5D0-7B41AD4125BC}"/>
          </ac:picMkLst>
        </pc:picChg>
        <pc:picChg chg="add mod">
          <ac:chgData name="Zaidi, Sadia" userId="145bb054-69df-4ca4-bbf9-5b2a9f131ead" providerId="ADAL" clId="{25169489-75FA-0D4F-B3E6-5AA04D7B9810}" dt="2024-04-15T18:34:09.874" v="2470" actId="408"/>
          <ac:picMkLst>
            <pc:docMk/>
            <pc:sldMk cId="430419261" sldId="276"/>
            <ac:picMk id="21" creationId="{357BA3E3-7395-A78E-E3A0-75E89AF46E98}"/>
          </ac:picMkLst>
        </pc:picChg>
        <pc:cxnChg chg="mod">
          <ac:chgData name="Zaidi, Sadia" userId="145bb054-69df-4ca4-bbf9-5b2a9f131ead" providerId="ADAL" clId="{25169489-75FA-0D4F-B3E6-5AA04D7B9810}" dt="2024-04-15T18:34:09.874" v="2470" actId="408"/>
          <ac:cxnSpMkLst>
            <pc:docMk/>
            <pc:sldMk cId="430419261" sldId="276"/>
            <ac:cxnSpMk id="13" creationId="{21598EE8-BD82-2BC5-1FE0-5F19F8B99D08}"/>
          </ac:cxnSpMkLst>
        </pc:cxnChg>
        <pc:cxnChg chg="mod">
          <ac:chgData name="Zaidi, Sadia" userId="145bb054-69df-4ca4-bbf9-5b2a9f131ead" providerId="ADAL" clId="{25169489-75FA-0D4F-B3E6-5AA04D7B9810}" dt="2024-04-15T18:34:09.874" v="2470" actId="408"/>
          <ac:cxnSpMkLst>
            <pc:docMk/>
            <pc:sldMk cId="430419261" sldId="276"/>
            <ac:cxnSpMk id="25" creationId="{A1BA36EF-0F95-D3E7-7515-C4A3ECD99183}"/>
          </ac:cxnSpMkLst>
        </pc:cxnChg>
        <pc:cxnChg chg="mod">
          <ac:chgData name="Zaidi, Sadia" userId="145bb054-69df-4ca4-bbf9-5b2a9f131ead" providerId="ADAL" clId="{25169489-75FA-0D4F-B3E6-5AA04D7B9810}" dt="2024-04-15T18:34:09.874" v="2470" actId="408"/>
          <ac:cxnSpMkLst>
            <pc:docMk/>
            <pc:sldMk cId="430419261" sldId="276"/>
            <ac:cxnSpMk id="29" creationId="{57407973-B760-3643-93C2-6F182B2237C8}"/>
          </ac:cxnSpMkLst>
        </pc:cxnChg>
        <pc:cxnChg chg="mod topLvl">
          <ac:chgData name="Zaidi, Sadia" userId="145bb054-69df-4ca4-bbf9-5b2a9f131ead" providerId="ADAL" clId="{25169489-75FA-0D4F-B3E6-5AA04D7B9810}" dt="2024-04-15T18:20:34.304" v="2203" actId="338"/>
          <ac:cxnSpMkLst>
            <pc:docMk/>
            <pc:sldMk cId="430419261" sldId="276"/>
            <ac:cxnSpMk id="31" creationId="{BE16404F-273D-41DE-346C-36F624DE3D0B}"/>
          </ac:cxnSpMkLst>
        </pc:cxnChg>
      </pc:sldChg>
      <pc:sldChg chg="add del ord">
        <pc:chgData name="Zaidi, Sadia" userId="145bb054-69df-4ca4-bbf9-5b2a9f131ead" providerId="ADAL" clId="{25169489-75FA-0D4F-B3E6-5AA04D7B9810}" dt="2024-04-15T17:25:19.549" v="802" actId="2696"/>
        <pc:sldMkLst>
          <pc:docMk/>
          <pc:sldMk cId="3190010174" sldId="276"/>
        </pc:sldMkLst>
      </pc:sldChg>
      <pc:sldChg chg="modSp add del mod ord">
        <pc:chgData name="Zaidi, Sadia" userId="145bb054-69df-4ca4-bbf9-5b2a9f131ead" providerId="ADAL" clId="{25169489-75FA-0D4F-B3E6-5AA04D7B9810}" dt="2024-04-15T18:16:21.296" v="2142" actId="2696"/>
        <pc:sldMkLst>
          <pc:docMk/>
          <pc:sldMk cId="1697961182" sldId="277"/>
        </pc:sldMkLst>
        <pc:spChg chg="mod">
          <ac:chgData name="Zaidi, Sadia" userId="145bb054-69df-4ca4-bbf9-5b2a9f131ead" providerId="ADAL" clId="{25169489-75FA-0D4F-B3E6-5AA04D7B9810}" dt="2024-04-15T18:04:22.395" v="2139" actId="20577"/>
          <ac:spMkLst>
            <pc:docMk/>
            <pc:sldMk cId="1697961182" sldId="277"/>
            <ac:spMk id="2" creationId="{D8A80D0F-845A-F40D-95E7-C754817E807B}"/>
          </ac:spMkLst>
        </pc:spChg>
        <pc:grpChg chg="mod">
          <ac:chgData name="Zaidi, Sadia" userId="145bb054-69df-4ca4-bbf9-5b2a9f131ead" providerId="ADAL" clId="{25169489-75FA-0D4F-B3E6-5AA04D7B9810}" dt="2024-04-15T18:05:45.747" v="2141" actId="14100"/>
          <ac:grpSpMkLst>
            <pc:docMk/>
            <pc:sldMk cId="1697961182" sldId="277"/>
            <ac:grpSpMk id="24" creationId="{7A275215-BF50-46F1-6B0E-A227F7528F61}"/>
          </ac:grpSpMkLst>
        </pc:grpChg>
        <pc:grpChg chg="mod">
          <ac:chgData name="Zaidi, Sadia" userId="145bb054-69df-4ca4-bbf9-5b2a9f131ead" providerId="ADAL" clId="{25169489-75FA-0D4F-B3E6-5AA04D7B9810}" dt="2024-04-15T18:05:45.747" v="2141" actId="14100"/>
          <ac:grpSpMkLst>
            <pc:docMk/>
            <pc:sldMk cId="1697961182" sldId="277"/>
            <ac:grpSpMk id="25" creationId="{A405B3F9-1BDF-3DEC-F8BE-5212FC233B37}"/>
          </ac:grpSpMkLst>
        </pc:grpChg>
        <pc:picChg chg="mod">
          <ac:chgData name="Zaidi, Sadia" userId="145bb054-69df-4ca4-bbf9-5b2a9f131ead" providerId="ADAL" clId="{25169489-75FA-0D4F-B3E6-5AA04D7B9810}" dt="2024-04-15T18:05:45.747" v="2141" actId="14100"/>
          <ac:picMkLst>
            <pc:docMk/>
            <pc:sldMk cId="1697961182" sldId="277"/>
            <ac:picMk id="4" creationId="{5F70C439-5B77-78E6-3B33-2095734F97EC}"/>
          </ac:picMkLst>
        </pc:picChg>
        <pc:picChg chg="mod">
          <ac:chgData name="Zaidi, Sadia" userId="145bb054-69df-4ca4-bbf9-5b2a9f131ead" providerId="ADAL" clId="{25169489-75FA-0D4F-B3E6-5AA04D7B9810}" dt="2024-04-15T18:05:45.747" v="2141" actId="14100"/>
          <ac:picMkLst>
            <pc:docMk/>
            <pc:sldMk cId="1697961182" sldId="277"/>
            <ac:picMk id="8" creationId="{883B688D-E233-2F5D-A21C-367C3D185836}"/>
          </ac:picMkLst>
        </pc:picChg>
        <pc:picChg chg="mod">
          <ac:chgData name="Zaidi, Sadia" userId="145bb054-69df-4ca4-bbf9-5b2a9f131ead" providerId="ADAL" clId="{25169489-75FA-0D4F-B3E6-5AA04D7B9810}" dt="2024-04-15T18:05:45.747" v="2141" actId="14100"/>
          <ac:picMkLst>
            <pc:docMk/>
            <pc:sldMk cId="1697961182" sldId="277"/>
            <ac:picMk id="11" creationId="{76D31661-CE2F-75FC-CBED-B917034F2F72}"/>
          </ac:picMkLst>
        </pc:picChg>
      </pc:sldChg>
      <pc:sldChg chg="add del">
        <pc:chgData name="Zaidi, Sadia" userId="145bb054-69df-4ca4-bbf9-5b2a9f131ead" providerId="ADAL" clId="{25169489-75FA-0D4F-B3E6-5AA04D7B9810}" dt="2024-04-15T17:46:26.342" v="1186"/>
        <pc:sldMkLst>
          <pc:docMk/>
          <pc:sldMk cId="2975887590" sldId="278"/>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8BD6393-D24A-B940-B14D-AC68314C7269}" type="datetimeFigureOut">
              <a:rPr lang="en-US" smtClean="0"/>
              <a:t>5/8/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CBE0EED-F284-C744-9F08-16497F717B34}" type="slidenum">
              <a:rPr lang="en-US" smtClean="0"/>
              <a:t>‹#›</a:t>
            </a:fld>
            <a:endParaRPr lang="en-US"/>
          </a:p>
        </p:txBody>
      </p:sp>
    </p:spTree>
    <p:extLst>
      <p:ext uri="{BB962C8B-B14F-4D97-AF65-F5344CB8AC3E}">
        <p14:creationId xmlns:p14="http://schemas.microsoft.com/office/powerpoint/2010/main" val="17134488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1CBE0EED-F284-C744-9F08-16497F717B34}" type="slidenum">
              <a:rPr lang="en-US" smtClean="0"/>
              <a:t>2</a:t>
            </a:fld>
            <a:endParaRPr lang="en-US"/>
          </a:p>
        </p:txBody>
      </p:sp>
    </p:spTree>
    <p:extLst>
      <p:ext uri="{BB962C8B-B14F-4D97-AF65-F5344CB8AC3E}">
        <p14:creationId xmlns:p14="http://schemas.microsoft.com/office/powerpoint/2010/main" val="27384337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EFA02D-88ED-2921-B8B7-C535D3641F4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BFDA891-31F8-6DC7-95DE-236BFCA5723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1C31DD5-136A-315F-E7AD-8619CF389261}"/>
              </a:ext>
            </a:extLst>
          </p:cNvPr>
          <p:cNvSpPr>
            <a:spLocks noGrp="1"/>
          </p:cNvSpPr>
          <p:nvPr>
            <p:ph type="dt" sz="half" idx="10"/>
          </p:nvPr>
        </p:nvSpPr>
        <p:spPr/>
        <p:txBody>
          <a:bodyPr/>
          <a:lstStyle/>
          <a:p>
            <a:fld id="{E5736868-C3D1-B349-8C9E-B56015416D40}" type="datetime1">
              <a:rPr lang="en-US" smtClean="0"/>
              <a:t>5/8/2024</a:t>
            </a:fld>
            <a:endParaRPr lang="en-US"/>
          </a:p>
        </p:txBody>
      </p:sp>
      <p:sp>
        <p:nvSpPr>
          <p:cNvPr id="5" name="Footer Placeholder 4">
            <a:extLst>
              <a:ext uri="{FF2B5EF4-FFF2-40B4-BE49-F238E27FC236}">
                <a16:creationId xmlns:a16="http://schemas.microsoft.com/office/drawing/2014/main" id="{2AEB978E-F478-700B-10F0-7E8FAD175F0C}"/>
              </a:ext>
            </a:extLst>
          </p:cNvPr>
          <p:cNvSpPr>
            <a:spLocks noGrp="1"/>
          </p:cNvSpPr>
          <p:nvPr>
            <p:ph type="ftr" sz="quarter" idx="11"/>
          </p:nvPr>
        </p:nvSpPr>
        <p:spPr/>
        <p:txBody>
          <a:bodyPr/>
          <a:lstStyle/>
          <a:p>
            <a:endParaRPr lang="en-US"/>
          </a:p>
        </p:txBody>
      </p:sp>
    </p:spTree>
    <p:extLst>
      <p:ext uri="{BB962C8B-B14F-4D97-AF65-F5344CB8AC3E}">
        <p14:creationId xmlns:p14="http://schemas.microsoft.com/office/powerpoint/2010/main" val="24739274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D861FD-335A-2121-F8DE-EB6F9CC8A37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716D8EA-FC53-3773-9283-981ED01471E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B055CB-4E65-BFCA-F090-F605AD8A331D}"/>
              </a:ext>
            </a:extLst>
          </p:cNvPr>
          <p:cNvSpPr>
            <a:spLocks noGrp="1"/>
          </p:cNvSpPr>
          <p:nvPr>
            <p:ph type="dt" sz="half" idx="10"/>
          </p:nvPr>
        </p:nvSpPr>
        <p:spPr/>
        <p:txBody>
          <a:bodyPr/>
          <a:lstStyle/>
          <a:p>
            <a:fld id="{F95584FC-8CBD-8040-9EE1-55922E4B9AA6}" type="datetime1">
              <a:rPr lang="en-US" smtClean="0"/>
              <a:t>5/8/2024</a:t>
            </a:fld>
            <a:endParaRPr lang="en-US"/>
          </a:p>
        </p:txBody>
      </p:sp>
      <p:sp>
        <p:nvSpPr>
          <p:cNvPr id="5" name="Footer Placeholder 4">
            <a:extLst>
              <a:ext uri="{FF2B5EF4-FFF2-40B4-BE49-F238E27FC236}">
                <a16:creationId xmlns:a16="http://schemas.microsoft.com/office/drawing/2014/main" id="{D8D7AD51-D92F-5D64-E9DE-F3EA5EA3E2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12D0540-5E87-19A6-41B8-A97BEF50B43E}"/>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7044956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812F55B-9F69-F7CD-6D20-A01CFD58496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F32C1AE-C6DC-1842-2D75-66519C397C6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FF5D7A-9069-D04D-7863-46A91997D339}"/>
              </a:ext>
            </a:extLst>
          </p:cNvPr>
          <p:cNvSpPr>
            <a:spLocks noGrp="1"/>
          </p:cNvSpPr>
          <p:nvPr>
            <p:ph type="dt" sz="half" idx="10"/>
          </p:nvPr>
        </p:nvSpPr>
        <p:spPr/>
        <p:txBody>
          <a:bodyPr/>
          <a:lstStyle/>
          <a:p>
            <a:fld id="{543D5DAB-FC7E-F945-953F-8B76569196B8}" type="datetime1">
              <a:rPr lang="en-US" smtClean="0"/>
              <a:t>5/8/2024</a:t>
            </a:fld>
            <a:endParaRPr lang="en-US"/>
          </a:p>
        </p:txBody>
      </p:sp>
      <p:sp>
        <p:nvSpPr>
          <p:cNvPr id="5" name="Footer Placeholder 4">
            <a:extLst>
              <a:ext uri="{FF2B5EF4-FFF2-40B4-BE49-F238E27FC236}">
                <a16:creationId xmlns:a16="http://schemas.microsoft.com/office/drawing/2014/main" id="{7D749609-9CBF-A2BB-6CB4-A90581C5BD6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A631F98-A8E3-F449-97E7-1F7F3D027D84}"/>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1520859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7F7145-60C3-E875-1065-AF4A0098A71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E299F1E-753F-DB82-B9DD-22B39A6A9E7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B866573-3835-4BA4-59D9-01576D5CED4A}"/>
              </a:ext>
            </a:extLst>
          </p:cNvPr>
          <p:cNvSpPr>
            <a:spLocks noGrp="1"/>
          </p:cNvSpPr>
          <p:nvPr>
            <p:ph type="dt" sz="half" idx="10"/>
          </p:nvPr>
        </p:nvSpPr>
        <p:spPr/>
        <p:txBody>
          <a:bodyPr/>
          <a:lstStyle/>
          <a:p>
            <a:fld id="{ED12A27F-236D-CB41-8AB3-C3D95361235B}" type="datetime1">
              <a:rPr lang="en-US" smtClean="0"/>
              <a:t>5/8/2024</a:t>
            </a:fld>
            <a:endParaRPr lang="en-US"/>
          </a:p>
        </p:txBody>
      </p:sp>
      <p:sp>
        <p:nvSpPr>
          <p:cNvPr id="5" name="Footer Placeholder 4">
            <a:extLst>
              <a:ext uri="{FF2B5EF4-FFF2-40B4-BE49-F238E27FC236}">
                <a16:creationId xmlns:a16="http://schemas.microsoft.com/office/drawing/2014/main" id="{A95A801E-5C10-24E7-1689-0C455089C27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2E64CEA-2ECD-5C83-3A79-413A248D3E99}"/>
              </a:ext>
            </a:extLst>
          </p:cNvPr>
          <p:cNvSpPr>
            <a:spLocks noGrp="1"/>
          </p:cNvSpPr>
          <p:nvPr>
            <p:ph type="sldNum" sz="quarter" idx="12"/>
          </p:nvPr>
        </p:nvSpPr>
        <p:spPr/>
        <p:txBody>
          <a:bodyPr/>
          <a:lstStyle/>
          <a:p>
            <a:r>
              <a:rPr lang="en-US"/>
              <a:t>Page </a:t>
            </a:r>
            <a:fld id="{CE3DC82A-4763-0846-9702-01F3D3003FD6}" type="slidenum">
              <a:rPr lang="en-US" smtClean="0"/>
              <a:pPr/>
              <a:t>‹#›</a:t>
            </a:fld>
            <a:endParaRPr lang="en-US"/>
          </a:p>
        </p:txBody>
      </p:sp>
    </p:spTree>
    <p:extLst>
      <p:ext uri="{BB962C8B-B14F-4D97-AF65-F5344CB8AC3E}">
        <p14:creationId xmlns:p14="http://schemas.microsoft.com/office/powerpoint/2010/main" val="13541171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31C9B1-CE2C-76AB-FAF6-8A0281B8751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9394B39-C61F-AAF4-3127-1A53F953CE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787BCA4-8F5A-179A-3CAE-79C9B4AD6D7D}"/>
              </a:ext>
            </a:extLst>
          </p:cNvPr>
          <p:cNvSpPr>
            <a:spLocks noGrp="1"/>
          </p:cNvSpPr>
          <p:nvPr>
            <p:ph type="dt" sz="half" idx="10"/>
          </p:nvPr>
        </p:nvSpPr>
        <p:spPr/>
        <p:txBody>
          <a:bodyPr/>
          <a:lstStyle/>
          <a:p>
            <a:fld id="{D0618107-A77E-534A-A40D-EB7FEABCC725}" type="datetime1">
              <a:rPr lang="en-US" smtClean="0"/>
              <a:t>5/8/2024</a:t>
            </a:fld>
            <a:endParaRPr lang="en-US"/>
          </a:p>
        </p:txBody>
      </p:sp>
      <p:sp>
        <p:nvSpPr>
          <p:cNvPr id="5" name="Footer Placeholder 4">
            <a:extLst>
              <a:ext uri="{FF2B5EF4-FFF2-40B4-BE49-F238E27FC236}">
                <a16:creationId xmlns:a16="http://schemas.microsoft.com/office/drawing/2014/main" id="{362D10DF-7E6D-9ACD-4209-3F4C5AAC11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DB40AD-2079-0C2E-22B4-E01329DE10B9}"/>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36562538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3AE1E3-E69E-2E0F-BDD0-A7A168EF2BE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26E8CE4-291B-A54B-927E-E815013FA70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4F0C84E-3CDD-5A4A-9B57-5B540E77D7C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9EF63A9-DCC3-FDD9-3103-C937DE5DC5F5}"/>
              </a:ext>
            </a:extLst>
          </p:cNvPr>
          <p:cNvSpPr>
            <a:spLocks noGrp="1"/>
          </p:cNvSpPr>
          <p:nvPr>
            <p:ph type="dt" sz="half" idx="10"/>
          </p:nvPr>
        </p:nvSpPr>
        <p:spPr/>
        <p:txBody>
          <a:bodyPr/>
          <a:lstStyle/>
          <a:p>
            <a:fld id="{B501FC86-3BD0-FD46-A380-1BC0C5450885}" type="datetime1">
              <a:rPr lang="en-US" smtClean="0"/>
              <a:t>5/8/2024</a:t>
            </a:fld>
            <a:endParaRPr lang="en-US"/>
          </a:p>
        </p:txBody>
      </p:sp>
      <p:sp>
        <p:nvSpPr>
          <p:cNvPr id="6" name="Footer Placeholder 5">
            <a:extLst>
              <a:ext uri="{FF2B5EF4-FFF2-40B4-BE49-F238E27FC236}">
                <a16:creationId xmlns:a16="http://schemas.microsoft.com/office/drawing/2014/main" id="{8E9ACC7E-FA04-BB05-1BE4-5A9B944CF32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BBEFCB-E3E5-C3B5-24C6-C4432B098304}"/>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34231209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103322-E9E1-570B-D403-CEFA9492C2A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187303E-1BAC-B26B-48DC-43653B31D4B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667D424-7D35-43E7-C97E-58CA594D7DF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E90336C-CF84-33D7-DD3B-61FF8635EEC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FF13480-C6CB-B1F6-1319-86BAA216B11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36C4DC6-C676-EBBB-2448-430DA00D24ED}"/>
              </a:ext>
            </a:extLst>
          </p:cNvPr>
          <p:cNvSpPr>
            <a:spLocks noGrp="1"/>
          </p:cNvSpPr>
          <p:nvPr>
            <p:ph type="dt" sz="half" idx="10"/>
          </p:nvPr>
        </p:nvSpPr>
        <p:spPr/>
        <p:txBody>
          <a:bodyPr/>
          <a:lstStyle/>
          <a:p>
            <a:fld id="{8BACDB9B-0D33-B044-8484-57D62C7B8EE5}" type="datetime1">
              <a:rPr lang="en-US" smtClean="0"/>
              <a:t>5/8/2024</a:t>
            </a:fld>
            <a:endParaRPr lang="en-US"/>
          </a:p>
        </p:txBody>
      </p:sp>
      <p:sp>
        <p:nvSpPr>
          <p:cNvPr id="8" name="Footer Placeholder 7">
            <a:extLst>
              <a:ext uri="{FF2B5EF4-FFF2-40B4-BE49-F238E27FC236}">
                <a16:creationId xmlns:a16="http://schemas.microsoft.com/office/drawing/2014/main" id="{557FF2D7-D660-E20C-898A-74D690815D1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7DC9EAB-0AD2-5931-6C49-A408B612CF44}"/>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40746501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3810C7-0EF4-86BE-A475-EEFA40C22FC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EDF8F1E-2C81-12CE-535A-072691A4DD7C}"/>
              </a:ext>
            </a:extLst>
          </p:cNvPr>
          <p:cNvSpPr>
            <a:spLocks noGrp="1"/>
          </p:cNvSpPr>
          <p:nvPr>
            <p:ph type="dt" sz="half" idx="10"/>
          </p:nvPr>
        </p:nvSpPr>
        <p:spPr/>
        <p:txBody>
          <a:bodyPr/>
          <a:lstStyle/>
          <a:p>
            <a:fld id="{6CD2FA6F-2849-154A-9582-EB251ABC0DFB}" type="datetime1">
              <a:rPr lang="en-US" smtClean="0"/>
              <a:t>5/8/2024</a:t>
            </a:fld>
            <a:endParaRPr lang="en-US"/>
          </a:p>
        </p:txBody>
      </p:sp>
      <p:sp>
        <p:nvSpPr>
          <p:cNvPr id="4" name="Footer Placeholder 3">
            <a:extLst>
              <a:ext uri="{FF2B5EF4-FFF2-40B4-BE49-F238E27FC236}">
                <a16:creationId xmlns:a16="http://schemas.microsoft.com/office/drawing/2014/main" id="{334AC482-FE2C-B0B5-5403-3F9C965BB36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BDE71F-44EA-8627-658F-7CED0161BEE2}"/>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1645396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8CBE7CE-9BA2-2D1E-F92B-4AFCB50760AA}"/>
              </a:ext>
            </a:extLst>
          </p:cNvPr>
          <p:cNvSpPr>
            <a:spLocks noGrp="1"/>
          </p:cNvSpPr>
          <p:nvPr>
            <p:ph type="dt" sz="half" idx="10"/>
          </p:nvPr>
        </p:nvSpPr>
        <p:spPr/>
        <p:txBody>
          <a:bodyPr/>
          <a:lstStyle/>
          <a:p>
            <a:fld id="{8BBF75FE-B9F1-B24E-8A86-392459E66129}" type="datetime1">
              <a:rPr lang="en-US" smtClean="0"/>
              <a:t>5/8/2024</a:t>
            </a:fld>
            <a:endParaRPr lang="en-US"/>
          </a:p>
        </p:txBody>
      </p:sp>
      <p:sp>
        <p:nvSpPr>
          <p:cNvPr id="3" name="Footer Placeholder 2">
            <a:extLst>
              <a:ext uri="{FF2B5EF4-FFF2-40B4-BE49-F238E27FC236}">
                <a16:creationId xmlns:a16="http://schemas.microsoft.com/office/drawing/2014/main" id="{6B5F7651-0D4A-5CB6-1631-4A305E072E0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0B54ED0-0E16-45F0-FF8E-5FD5A6EA8B87}"/>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41912341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03DC26-762B-7F4F-5323-3DAD0687C6E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84086BB-B83C-9F0C-D28B-2B7AA909D02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C78F675-DD62-2700-E9CC-A0AB05CB177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407AC55-D0A5-7A22-2C33-27D8DEF15F0F}"/>
              </a:ext>
            </a:extLst>
          </p:cNvPr>
          <p:cNvSpPr>
            <a:spLocks noGrp="1"/>
          </p:cNvSpPr>
          <p:nvPr>
            <p:ph type="dt" sz="half" idx="10"/>
          </p:nvPr>
        </p:nvSpPr>
        <p:spPr/>
        <p:txBody>
          <a:bodyPr/>
          <a:lstStyle/>
          <a:p>
            <a:fld id="{B2406FF3-8A17-8245-8C69-7389399FEA8C}" type="datetime1">
              <a:rPr lang="en-US" smtClean="0"/>
              <a:t>5/8/2024</a:t>
            </a:fld>
            <a:endParaRPr lang="en-US"/>
          </a:p>
        </p:txBody>
      </p:sp>
      <p:sp>
        <p:nvSpPr>
          <p:cNvPr id="6" name="Footer Placeholder 5">
            <a:extLst>
              <a:ext uri="{FF2B5EF4-FFF2-40B4-BE49-F238E27FC236}">
                <a16:creationId xmlns:a16="http://schemas.microsoft.com/office/drawing/2014/main" id="{BB534443-9206-AD5D-4E7B-FB43325F871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BC4C86C-5A08-D2D4-AE39-12E2226774FB}"/>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13457308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1EAAF3-A19A-716E-1647-3D415C8651E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99B5D39-3F51-16D2-8F5C-04088173FDB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7D117C4-C28C-93B0-BDCC-51C078D6257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84473B3-C373-C4C8-FA18-C56442DCF12C}"/>
              </a:ext>
            </a:extLst>
          </p:cNvPr>
          <p:cNvSpPr>
            <a:spLocks noGrp="1"/>
          </p:cNvSpPr>
          <p:nvPr>
            <p:ph type="dt" sz="half" idx="10"/>
          </p:nvPr>
        </p:nvSpPr>
        <p:spPr/>
        <p:txBody>
          <a:bodyPr/>
          <a:lstStyle/>
          <a:p>
            <a:fld id="{15F3EDB3-9830-D249-9377-1D1147F43C92}" type="datetime1">
              <a:rPr lang="en-US" smtClean="0"/>
              <a:t>5/8/2024</a:t>
            </a:fld>
            <a:endParaRPr lang="en-US"/>
          </a:p>
        </p:txBody>
      </p:sp>
      <p:sp>
        <p:nvSpPr>
          <p:cNvPr id="6" name="Footer Placeholder 5">
            <a:extLst>
              <a:ext uri="{FF2B5EF4-FFF2-40B4-BE49-F238E27FC236}">
                <a16:creationId xmlns:a16="http://schemas.microsoft.com/office/drawing/2014/main" id="{C21B9DBC-B629-16F7-9A95-8AC95B7F7F4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E503AC-E20E-D5D6-72A1-17B23481CFA2}"/>
              </a:ext>
            </a:extLst>
          </p:cNvPr>
          <p:cNvSpPr>
            <a:spLocks noGrp="1"/>
          </p:cNvSpPr>
          <p:nvPr>
            <p:ph type="sldNum" sz="quarter" idx="12"/>
          </p:nvPr>
        </p:nvSpPr>
        <p:spPr/>
        <p:txBody>
          <a:bodyPr/>
          <a:lstStyle/>
          <a:p>
            <a:fld id="{F3A1540D-E16E-8049-B101-3B342E88681D}" type="slidenum">
              <a:rPr lang="en-US" smtClean="0"/>
              <a:t>‹#›</a:t>
            </a:fld>
            <a:endParaRPr lang="en-US"/>
          </a:p>
        </p:txBody>
      </p:sp>
    </p:spTree>
    <p:extLst>
      <p:ext uri="{BB962C8B-B14F-4D97-AF65-F5344CB8AC3E}">
        <p14:creationId xmlns:p14="http://schemas.microsoft.com/office/powerpoint/2010/main" val="25451967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B15A89E-B8EB-5178-03FF-EB71E8A0B46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7077BCF-B90F-E11C-DC18-6E8E2864E58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70CF1D-D816-C8C5-74BE-79300CE8EAC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0BE288-798D-9A4B-BE8A-BE5E8E6C8757}" type="datetime1">
              <a:rPr lang="en-US" smtClean="0"/>
              <a:t>5/8/2024</a:t>
            </a:fld>
            <a:endParaRPr lang="en-US"/>
          </a:p>
        </p:txBody>
      </p:sp>
      <p:sp>
        <p:nvSpPr>
          <p:cNvPr id="5" name="Footer Placeholder 4">
            <a:extLst>
              <a:ext uri="{FF2B5EF4-FFF2-40B4-BE49-F238E27FC236}">
                <a16:creationId xmlns:a16="http://schemas.microsoft.com/office/drawing/2014/main" id="{EE07645D-65CC-8133-645B-04CADB09C37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A725AEE-165C-CE5E-5139-5089C2E5C20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solidFill>
              </a:defRPr>
            </a:lvl1pPr>
          </a:lstStyle>
          <a:p>
            <a:r>
              <a:rPr lang="en-US"/>
              <a:t>Page </a:t>
            </a:r>
            <a:fld id="{F3A1540D-E16E-8049-B101-3B342E88681D}" type="slidenum">
              <a:rPr lang="en-US" smtClean="0"/>
              <a:pPr/>
              <a:t>‹#›</a:t>
            </a:fld>
            <a:endParaRPr lang="en-US"/>
          </a:p>
        </p:txBody>
      </p:sp>
    </p:spTree>
    <p:extLst>
      <p:ext uri="{BB962C8B-B14F-4D97-AF65-F5344CB8AC3E}">
        <p14:creationId xmlns:p14="http://schemas.microsoft.com/office/powerpoint/2010/main" val="34056455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hyperlink" Target="https://testflight.apple.com/"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3.jpeg"/><Relationship Id="rId5" Type="http://schemas.openxmlformats.org/officeDocument/2006/relationships/image" Target="../media/image2.jpeg"/><Relationship Id="rId4"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2.xml"/><Relationship Id="rId6" Type="http://schemas.openxmlformats.org/officeDocument/2006/relationships/image" Target="../media/image8.jpeg"/><Relationship Id="rId5" Type="http://schemas.openxmlformats.org/officeDocument/2006/relationships/image" Target="../media/image7.jpeg"/><Relationship Id="rId4" Type="http://schemas.openxmlformats.org/officeDocument/2006/relationships/image" Target="../media/image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F93EBF-DEB6-D97B-A049-5A8400080EEB}"/>
              </a:ext>
            </a:extLst>
          </p:cNvPr>
          <p:cNvSpPr>
            <a:spLocks noGrp="1"/>
          </p:cNvSpPr>
          <p:nvPr>
            <p:ph type="ctrTitle"/>
          </p:nvPr>
        </p:nvSpPr>
        <p:spPr>
          <a:xfrm>
            <a:off x="1524000" y="1122363"/>
            <a:ext cx="9144000" cy="1932122"/>
          </a:xfrm>
        </p:spPr>
        <p:txBody>
          <a:bodyPr/>
          <a:lstStyle/>
          <a:p>
            <a:r>
              <a:rPr lang="en-US" sz="3600">
                <a:latin typeface="Calibri" panose="020F0502020204030204" pitchFamily="34" charset="0"/>
                <a:cs typeface="Times New Roman" panose="02020603050405020304" pitchFamily="18" charset="0"/>
              </a:rPr>
              <a:t>Otsuka Mindful Tea Ritual </a:t>
            </a:r>
            <a:r>
              <a:rPr lang="en-US" sz="3600">
                <a:effectLst/>
                <a:latin typeface="Calibri" panose="020F0502020204030204" pitchFamily="34" charset="0"/>
                <a:ea typeface="Calibri" panose="020F0502020204030204" pitchFamily="34" charset="0"/>
                <a:cs typeface="Times New Roman" panose="02020603050405020304" pitchFamily="18" charset="0"/>
              </a:rPr>
              <a:t>App</a:t>
            </a:r>
            <a:br>
              <a:rPr lang="en-US" sz="3600">
                <a:effectLst/>
                <a:latin typeface="Calibri" panose="020F0502020204030204" pitchFamily="34" charset="0"/>
                <a:ea typeface="Calibri" panose="020F0502020204030204" pitchFamily="34" charset="0"/>
                <a:cs typeface="Times New Roman" panose="02020603050405020304" pitchFamily="18" charset="0"/>
              </a:rPr>
            </a:br>
            <a:r>
              <a:rPr lang="en-US" sz="3600">
                <a:effectLst/>
                <a:latin typeface="Calibri" panose="020F0502020204030204" pitchFamily="34" charset="0"/>
                <a:ea typeface="Calibri" panose="020F0502020204030204" pitchFamily="34" charset="0"/>
                <a:cs typeface="Times New Roman" panose="02020603050405020304" pitchFamily="18" charset="0"/>
              </a:rPr>
              <a:t>iOS Installation Instructions</a:t>
            </a:r>
            <a:br>
              <a:rPr lang="en-US" sz="1800">
                <a:effectLst/>
                <a:latin typeface="Calibri" panose="020F0502020204030204" pitchFamily="34" charset="0"/>
                <a:ea typeface="Calibri" panose="020F0502020204030204" pitchFamily="34" charset="0"/>
                <a:cs typeface="Times New Roman" panose="02020603050405020304" pitchFamily="18" charset="0"/>
              </a:rPr>
            </a:br>
            <a:endParaRPr lang="en-US"/>
          </a:p>
        </p:txBody>
      </p:sp>
      <p:sp>
        <p:nvSpPr>
          <p:cNvPr id="3" name="Subtitle 2">
            <a:extLst>
              <a:ext uri="{FF2B5EF4-FFF2-40B4-BE49-F238E27FC236}">
                <a16:creationId xmlns:a16="http://schemas.microsoft.com/office/drawing/2014/main" id="{252A1690-D753-E080-63E4-5246465B9D03}"/>
              </a:ext>
            </a:extLst>
          </p:cNvPr>
          <p:cNvSpPr>
            <a:spLocks noGrp="1"/>
          </p:cNvSpPr>
          <p:nvPr>
            <p:ph type="subTitle" idx="1"/>
          </p:nvPr>
        </p:nvSpPr>
        <p:spPr>
          <a:xfrm>
            <a:off x="1524000" y="3097104"/>
            <a:ext cx="9144000" cy="1366736"/>
          </a:xfrm>
        </p:spPr>
        <p:txBody>
          <a:bodyPr vert="horz" lIns="91440" tIns="45720" rIns="91440" bIns="45720" rtlCol="0" anchor="t">
            <a:normAutofit/>
          </a:bodyPr>
          <a:lstStyle/>
          <a:p>
            <a:r>
              <a:rPr lang="en-US"/>
              <a:t>Version 9</a:t>
            </a:r>
          </a:p>
        </p:txBody>
      </p:sp>
      <p:sp>
        <p:nvSpPr>
          <p:cNvPr id="4" name="TextBox 3">
            <a:extLst>
              <a:ext uri="{FF2B5EF4-FFF2-40B4-BE49-F238E27FC236}">
                <a16:creationId xmlns:a16="http://schemas.microsoft.com/office/drawing/2014/main" id="{0BFA8ADE-3192-45C5-7E06-FD2A6C966662}"/>
              </a:ext>
            </a:extLst>
          </p:cNvPr>
          <p:cNvSpPr txBox="1"/>
          <p:nvPr/>
        </p:nvSpPr>
        <p:spPr>
          <a:xfrm>
            <a:off x="826852" y="4826490"/>
            <a:ext cx="11011709" cy="1477328"/>
          </a:xfrm>
          <a:prstGeom prst="rect">
            <a:avLst/>
          </a:prstGeom>
          <a:noFill/>
        </p:spPr>
        <p:txBody>
          <a:bodyPr wrap="square" lIns="91440" tIns="45720" rIns="91440" bIns="45720" rtlCol="0" anchor="t">
            <a:spAutoFit/>
          </a:bodyPr>
          <a:lstStyle/>
          <a:p>
            <a:pPr marL="0" marR="0">
              <a:spcBef>
                <a:spcPts val="0"/>
              </a:spcBef>
              <a:spcAft>
                <a:spcPts val="0"/>
              </a:spcAft>
            </a:pPr>
            <a:r>
              <a:rPr lang="en-US" sz="1800" b="1" i="1">
                <a:effectLst/>
                <a:latin typeface="Calibri" panose="020F0502020204030204" pitchFamily="34" charset="0"/>
                <a:ea typeface="Calibri" panose="020F0502020204030204" pitchFamily="34" charset="0"/>
                <a:cs typeface="Times New Roman" panose="02020603050405020304" pitchFamily="18" charset="0"/>
              </a:rPr>
              <a:t>Requirements</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p>
            <a:r>
              <a:rPr lang="en-US" sz="1800">
                <a:effectLst/>
                <a:latin typeface="Calibri"/>
                <a:ea typeface="Calibri"/>
                <a:cs typeface="Times New Roman"/>
              </a:rPr>
              <a:t>Two requirements exist to enable your iPhone to install the</a:t>
            </a:r>
            <a:r>
              <a:rPr lang="en-US">
                <a:latin typeface="Calibri"/>
                <a:ea typeface="Calibri"/>
                <a:cs typeface="Times New Roman"/>
              </a:rPr>
              <a:t> test</a:t>
            </a:r>
            <a:r>
              <a:rPr lang="en-US" sz="1800">
                <a:effectLst/>
                <a:latin typeface="Calibri"/>
                <a:ea typeface="Calibri"/>
                <a:cs typeface="Times New Roman"/>
              </a:rPr>
              <a:t> version of the Mindful Tea Ritual App.</a:t>
            </a:r>
          </a:p>
          <a:p>
            <a:pPr marL="342900" marR="0" lvl="0" indent="-342900">
              <a:spcBef>
                <a:spcPts val="0"/>
              </a:spcBef>
              <a:spcAft>
                <a:spcPts val="0"/>
              </a:spcAft>
              <a:buFont typeface="+mj-lt"/>
              <a:buAutoNum type="arabicPeriod"/>
            </a:pPr>
            <a:r>
              <a:rPr lang="en-US" sz="1800">
                <a:effectLst/>
                <a:latin typeface="Calibri" panose="020F0502020204030204" pitchFamily="34" charset="0"/>
                <a:ea typeface="Calibri" panose="020F0502020204030204" pitchFamily="34" charset="0"/>
                <a:cs typeface="Times New Roman" panose="02020603050405020304" pitchFamily="18" charset="0"/>
              </a:rPr>
              <a:t>An iPhone with the ability to download applications from Apple’s App Store</a:t>
            </a:r>
          </a:p>
          <a:p>
            <a:pPr marL="342900" marR="0" lvl="0" indent="-342900">
              <a:spcBef>
                <a:spcPts val="0"/>
              </a:spcBef>
              <a:spcAft>
                <a:spcPts val="0"/>
              </a:spcAft>
              <a:buFont typeface="+mj-lt"/>
              <a:buAutoNum type="arabicPeriod"/>
            </a:pPr>
            <a:r>
              <a:rPr lang="en-US" sz="1800">
                <a:effectLst/>
                <a:latin typeface="Calibri" panose="020F0502020204030204" pitchFamily="34" charset="0"/>
                <a:ea typeface="Calibri" panose="020F0502020204030204" pitchFamily="34" charset="0"/>
                <a:cs typeface="Times New Roman" panose="02020603050405020304" pitchFamily="18" charset="0"/>
              </a:rPr>
              <a:t>A valid email to receive installation instructions from Apple</a:t>
            </a:r>
          </a:p>
          <a:p>
            <a:endParaRPr lang="en-US"/>
          </a:p>
        </p:txBody>
      </p:sp>
      <p:sp>
        <p:nvSpPr>
          <p:cNvPr id="5" name="TextBox 4">
            <a:extLst>
              <a:ext uri="{FF2B5EF4-FFF2-40B4-BE49-F238E27FC236}">
                <a16:creationId xmlns:a16="http://schemas.microsoft.com/office/drawing/2014/main" id="{6F636A03-7C47-F846-C3F5-5E79E0F6D4CD}"/>
              </a:ext>
            </a:extLst>
          </p:cNvPr>
          <p:cNvSpPr txBox="1"/>
          <p:nvPr/>
        </p:nvSpPr>
        <p:spPr>
          <a:xfrm>
            <a:off x="10842171" y="6303818"/>
            <a:ext cx="184731" cy="369332"/>
          </a:xfrm>
          <a:prstGeom prst="rect">
            <a:avLst/>
          </a:prstGeom>
          <a:noFill/>
        </p:spPr>
        <p:txBody>
          <a:bodyPr wrap="none" rtlCol="0">
            <a:spAutoFit/>
          </a:bodyPr>
          <a:lstStyle/>
          <a:p>
            <a:endParaRPr lang="en-US"/>
          </a:p>
        </p:txBody>
      </p:sp>
    </p:spTree>
    <p:extLst>
      <p:ext uri="{BB962C8B-B14F-4D97-AF65-F5344CB8AC3E}">
        <p14:creationId xmlns:p14="http://schemas.microsoft.com/office/powerpoint/2010/main" val="22011294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9276B1-CD70-230A-B22D-C498614C64D9}"/>
              </a:ext>
            </a:extLst>
          </p:cNvPr>
          <p:cNvSpPr>
            <a:spLocks noGrp="1"/>
          </p:cNvSpPr>
          <p:nvPr>
            <p:ph type="title"/>
          </p:nvPr>
        </p:nvSpPr>
        <p:spPr>
          <a:xfrm>
            <a:off x="34446" y="95055"/>
            <a:ext cx="12123107" cy="1298347"/>
          </a:xfrm>
        </p:spPr>
        <p:txBody>
          <a:bodyPr>
            <a:noAutofit/>
          </a:bodyPr>
          <a:lstStyle/>
          <a:p>
            <a:pPr>
              <a:spcBef>
                <a:spcPts val="0"/>
              </a:spcBef>
            </a:pPr>
            <a:br>
              <a:rPr lang="en-US" sz="2000" b="1" i="1">
                <a:effectLst/>
                <a:latin typeface="Calibri"/>
                <a:ea typeface="Calibri"/>
                <a:cs typeface="Times New Roman"/>
              </a:rPr>
            </a:br>
            <a:br>
              <a:rPr lang="en-US" sz="2000" b="1" i="1">
                <a:effectLst/>
                <a:latin typeface="Calibri"/>
                <a:ea typeface="Calibri"/>
                <a:cs typeface="Times New Roman"/>
              </a:rPr>
            </a:br>
            <a:br>
              <a:rPr lang="en-US" sz="2000" b="1" i="1">
                <a:effectLst/>
                <a:latin typeface="Calibri"/>
                <a:ea typeface="Calibri"/>
                <a:cs typeface="Times New Roman"/>
              </a:rPr>
            </a:br>
            <a:r>
              <a:rPr lang="en-US" sz="1800" b="1" i="1">
                <a:effectLst/>
                <a:latin typeface="Calibri"/>
                <a:ea typeface="Calibri"/>
                <a:cs typeface="Times New Roman"/>
              </a:rPr>
              <a:t>TestFlight Installation</a:t>
            </a:r>
            <a:br>
              <a:rPr lang="en-US" sz="1400">
                <a:effectLst/>
                <a:latin typeface="Calibri" panose="020F0502020204030204" pitchFamily="34" charset="0"/>
                <a:ea typeface="Calibri" panose="020F0502020204030204" pitchFamily="34" charset="0"/>
                <a:cs typeface="Times New Roman" panose="02020603050405020304" pitchFamily="18" charset="0"/>
              </a:rPr>
            </a:br>
            <a:br>
              <a:rPr lang="en-US" sz="1400">
                <a:latin typeface="Calibri" panose="020F0502020204030204" pitchFamily="34" charset="0"/>
                <a:ea typeface="Calibri" panose="020F0502020204030204" pitchFamily="34" charset="0"/>
                <a:cs typeface="Times New Roman" panose="02020603050405020304" pitchFamily="18" charset="0"/>
              </a:rPr>
            </a:br>
            <a:r>
              <a:rPr lang="en-US" sz="1600">
                <a:latin typeface="Calibri"/>
                <a:cs typeface="Times New Roman"/>
              </a:rPr>
              <a:t>TestFlight is a platform created by Apple that allows developers to distribute beta versions of their iOS apps to a limited number of testers before releasing them to the public on the App Store.  </a:t>
            </a:r>
            <a:br>
              <a:rPr lang="en-US" sz="1600">
                <a:latin typeface="Calibri"/>
                <a:cs typeface="Times New Roman"/>
              </a:rPr>
            </a:br>
            <a:r>
              <a:rPr lang="en-US" sz="1600">
                <a:effectLst/>
                <a:latin typeface="Calibri"/>
                <a:ea typeface="Calibri"/>
                <a:cs typeface="Times New Roman"/>
              </a:rPr>
              <a:t>Please download and open TestFlight through the </a:t>
            </a:r>
            <a:r>
              <a:rPr lang="en-US" sz="1600">
                <a:latin typeface="Calibri"/>
                <a:ea typeface="Calibri"/>
                <a:cs typeface="Times New Roman"/>
              </a:rPr>
              <a:t>A</a:t>
            </a:r>
            <a:r>
              <a:rPr lang="en-US" sz="1600">
                <a:effectLst/>
                <a:latin typeface="Calibri"/>
                <a:ea typeface="Calibri"/>
                <a:cs typeface="Times New Roman"/>
              </a:rPr>
              <a:t>pp Store. Be sure to allow notifications when prompted and agree to the Terms and Conditions in the TestFlight App.</a:t>
            </a:r>
            <a:br>
              <a:rPr lang="en-US" sz="1600">
                <a:effectLst/>
                <a:latin typeface="Calibri"/>
                <a:ea typeface="Calibri"/>
                <a:cs typeface="Times New Roman"/>
              </a:rPr>
            </a:br>
            <a:r>
              <a:rPr lang="en-US" sz="1600">
                <a:latin typeface="Calibri"/>
                <a:ea typeface="Calibri"/>
                <a:cs typeface="Times New Roman"/>
              </a:rPr>
              <a:t>For additional details, please see </a:t>
            </a:r>
            <a:r>
              <a:rPr lang="en-US" sz="1600">
                <a:latin typeface="Calibri"/>
                <a:ea typeface="Calibri"/>
                <a:cs typeface="Times New Roman"/>
                <a:hlinkClick r:id="rId3"/>
              </a:rPr>
              <a:t>https://testflight.apple.com/</a:t>
            </a:r>
            <a:r>
              <a:rPr lang="en-US" sz="1600">
                <a:latin typeface="Calibri"/>
                <a:ea typeface="Calibri"/>
                <a:cs typeface="Times New Roman"/>
              </a:rPr>
              <a:t> section: </a:t>
            </a:r>
            <a:r>
              <a:rPr lang="en-US" sz="1600" i="1">
                <a:latin typeface="Calibri "/>
                <a:ea typeface="Calibri"/>
                <a:cs typeface="Times New Roman"/>
              </a:rPr>
              <a:t>I</a:t>
            </a:r>
            <a:r>
              <a:rPr lang="en-US" sz="1600" i="1">
                <a:solidFill>
                  <a:srgbClr val="111111"/>
                </a:solidFill>
                <a:effectLst/>
                <a:highlight>
                  <a:srgbClr val="FFFFFF"/>
                </a:highlight>
                <a:latin typeface="Calibri "/>
              </a:rPr>
              <a:t>nstalling a beta iOS or </a:t>
            </a:r>
            <a:r>
              <a:rPr lang="en-US" sz="1600" i="1" err="1">
                <a:solidFill>
                  <a:srgbClr val="111111"/>
                </a:solidFill>
                <a:effectLst/>
                <a:highlight>
                  <a:srgbClr val="FFFFFF"/>
                </a:highlight>
                <a:latin typeface="Calibri "/>
              </a:rPr>
              <a:t>iPadOS</a:t>
            </a:r>
            <a:r>
              <a:rPr lang="en-US" sz="1600" i="1">
                <a:solidFill>
                  <a:srgbClr val="111111"/>
                </a:solidFill>
                <a:effectLst/>
                <a:highlight>
                  <a:srgbClr val="FFFFFF"/>
                </a:highlight>
                <a:latin typeface="Calibri "/>
              </a:rPr>
              <a:t> app via email or public link invitation</a:t>
            </a:r>
            <a:br>
              <a:rPr lang="en-US" sz="1000" b="1" i="0">
                <a:solidFill>
                  <a:srgbClr val="111111"/>
                </a:solidFill>
                <a:effectLst/>
                <a:highlight>
                  <a:srgbClr val="FFFFFF"/>
                </a:highlight>
                <a:latin typeface="SF Pro Display"/>
              </a:rPr>
            </a:br>
            <a:br>
              <a:rPr lang="en-US" sz="2000">
                <a:ea typeface="+mj-lt"/>
                <a:cs typeface="+mj-lt"/>
              </a:rPr>
            </a:br>
            <a:endParaRPr lang="en-US" sz="2000">
              <a:latin typeface="Calibri"/>
              <a:ea typeface="Calibri"/>
              <a:cs typeface="Times New Roman"/>
            </a:endParaRPr>
          </a:p>
        </p:txBody>
      </p:sp>
      <p:sp>
        <p:nvSpPr>
          <p:cNvPr id="12" name="Slide Number Placeholder 11">
            <a:extLst>
              <a:ext uri="{FF2B5EF4-FFF2-40B4-BE49-F238E27FC236}">
                <a16:creationId xmlns:a16="http://schemas.microsoft.com/office/drawing/2014/main" id="{26C927A6-AC4A-1E55-4AC8-3D5B50F262C7}"/>
              </a:ext>
            </a:extLst>
          </p:cNvPr>
          <p:cNvSpPr>
            <a:spLocks noGrp="1"/>
          </p:cNvSpPr>
          <p:nvPr>
            <p:ph type="sldNum" sz="quarter" idx="12"/>
          </p:nvPr>
        </p:nvSpPr>
        <p:spPr>
          <a:xfrm>
            <a:off x="9002485" y="6308501"/>
            <a:ext cx="2743200" cy="365125"/>
          </a:xfrm>
        </p:spPr>
        <p:txBody>
          <a:bodyPr/>
          <a:lstStyle/>
          <a:p>
            <a:r>
              <a:rPr lang="en-US"/>
              <a:t>Page </a:t>
            </a:r>
            <a:fld id="{CE3DC82A-4763-0846-9702-01F3D3003FD6}" type="slidenum">
              <a:rPr lang="en-US" smtClean="0"/>
              <a:pPr/>
              <a:t>2</a:t>
            </a:fld>
            <a:endParaRPr lang="en-US"/>
          </a:p>
        </p:txBody>
      </p:sp>
      <p:pic>
        <p:nvPicPr>
          <p:cNvPr id="9" name="Picture 8">
            <a:extLst>
              <a:ext uri="{FF2B5EF4-FFF2-40B4-BE49-F238E27FC236}">
                <a16:creationId xmlns:a16="http://schemas.microsoft.com/office/drawing/2014/main" id="{66428C27-3F50-9859-D2D4-87AC7E0FE194}"/>
              </a:ext>
            </a:extLst>
          </p:cNvPr>
          <p:cNvPicPr>
            <a:picLocks noChangeAspect="1"/>
          </p:cNvPicPr>
          <p:nvPr/>
        </p:nvPicPr>
        <p:blipFill>
          <a:blip r:embed="rId4"/>
          <a:srcRect/>
          <a:stretch/>
        </p:blipFill>
        <p:spPr>
          <a:xfrm>
            <a:off x="1124567" y="2469223"/>
            <a:ext cx="2321129" cy="4293722"/>
          </a:xfrm>
          <a:prstGeom prst="rect">
            <a:avLst/>
          </a:prstGeom>
          <a:ln>
            <a:solidFill>
              <a:srgbClr val="4472C4"/>
            </a:solidFill>
          </a:ln>
        </p:spPr>
      </p:pic>
      <p:pic>
        <p:nvPicPr>
          <p:cNvPr id="16" name="Picture 15">
            <a:extLst>
              <a:ext uri="{FF2B5EF4-FFF2-40B4-BE49-F238E27FC236}">
                <a16:creationId xmlns:a16="http://schemas.microsoft.com/office/drawing/2014/main" id="{AE4B9BCE-3E4D-2366-895C-A69BDE232695}"/>
              </a:ext>
            </a:extLst>
          </p:cNvPr>
          <p:cNvPicPr>
            <a:picLocks noChangeAspect="1"/>
          </p:cNvPicPr>
          <p:nvPr/>
        </p:nvPicPr>
        <p:blipFill>
          <a:blip r:embed="rId5"/>
          <a:srcRect/>
          <a:stretch/>
        </p:blipFill>
        <p:spPr>
          <a:xfrm>
            <a:off x="4206687" y="2469222"/>
            <a:ext cx="2321129" cy="4293721"/>
          </a:xfrm>
          <a:prstGeom prst="rect">
            <a:avLst/>
          </a:prstGeom>
        </p:spPr>
      </p:pic>
      <p:pic>
        <p:nvPicPr>
          <p:cNvPr id="17" name="Picture 16" descr="Graphical user interface, text, application&#10;&#10;Description automatically generated">
            <a:extLst>
              <a:ext uri="{FF2B5EF4-FFF2-40B4-BE49-F238E27FC236}">
                <a16:creationId xmlns:a16="http://schemas.microsoft.com/office/drawing/2014/main" id="{700667C0-AF05-20E4-9489-6B0AB26A3941}"/>
              </a:ext>
            </a:extLst>
          </p:cNvPr>
          <p:cNvPicPr>
            <a:picLocks noChangeAspect="1"/>
          </p:cNvPicPr>
          <p:nvPr/>
        </p:nvPicPr>
        <p:blipFill>
          <a:blip r:embed="rId6"/>
          <a:stretch>
            <a:fillRect/>
          </a:stretch>
        </p:blipFill>
        <p:spPr>
          <a:xfrm>
            <a:off x="7288808" y="2469222"/>
            <a:ext cx="2321129" cy="4293722"/>
          </a:xfrm>
          <a:prstGeom prst="rect">
            <a:avLst/>
          </a:prstGeom>
          <a:ln>
            <a:solidFill>
              <a:srgbClr val="4472C4"/>
            </a:solidFill>
          </a:ln>
        </p:spPr>
      </p:pic>
      <p:sp>
        <p:nvSpPr>
          <p:cNvPr id="24" name="TextBox 23">
            <a:extLst>
              <a:ext uri="{FF2B5EF4-FFF2-40B4-BE49-F238E27FC236}">
                <a16:creationId xmlns:a16="http://schemas.microsoft.com/office/drawing/2014/main" id="{B1A1BFE8-1A2A-58FD-D67D-8EAB58A7B364}"/>
              </a:ext>
            </a:extLst>
          </p:cNvPr>
          <p:cNvSpPr txBox="1"/>
          <p:nvPr/>
        </p:nvSpPr>
        <p:spPr>
          <a:xfrm>
            <a:off x="1106095" y="1725627"/>
            <a:ext cx="2321129" cy="615553"/>
          </a:xfrm>
          <a:prstGeom prst="rect">
            <a:avLst/>
          </a:prstGeom>
          <a:noFill/>
        </p:spPr>
        <p:txBody>
          <a:bodyPr wrap="square">
            <a:spAutoFit/>
          </a:bodyPr>
          <a:lstStyle/>
          <a:p>
            <a:pPr algn="ctr"/>
            <a:r>
              <a:rPr lang="en-US" sz="1800" kern="1200">
                <a:solidFill>
                  <a:schemeClr val="tx1"/>
                </a:solidFill>
                <a:effectLst/>
                <a:latin typeface="+mn-lt"/>
                <a:ea typeface="+mn-ea"/>
                <a:cs typeface="+mn-cs"/>
              </a:rPr>
              <a:t>Image 1 </a:t>
            </a:r>
            <a:r>
              <a:rPr lang="en-US"/>
              <a:t>-</a:t>
            </a:r>
            <a:r>
              <a:rPr lang="en-US" sz="1800" kern="1200">
                <a:solidFill>
                  <a:schemeClr val="tx1"/>
                </a:solidFill>
                <a:effectLst/>
                <a:latin typeface="+mn-lt"/>
                <a:ea typeface="+mn-ea"/>
                <a:cs typeface="+mn-cs"/>
              </a:rPr>
              <a:t> </a:t>
            </a:r>
          </a:p>
          <a:p>
            <a:pPr algn="ctr"/>
            <a:r>
              <a:rPr lang="en-US" sz="1600" kern="1200">
                <a:solidFill>
                  <a:schemeClr val="tx1"/>
                </a:solidFill>
                <a:effectLst/>
                <a:latin typeface="+mn-lt"/>
                <a:ea typeface="+mn-ea"/>
                <a:cs typeface="+mn-cs"/>
              </a:rPr>
              <a:t>Download TestFlight</a:t>
            </a:r>
            <a:endParaRPr lang="en-US" sz="1600"/>
          </a:p>
        </p:txBody>
      </p:sp>
      <p:sp>
        <p:nvSpPr>
          <p:cNvPr id="25" name="TextBox 24">
            <a:extLst>
              <a:ext uri="{FF2B5EF4-FFF2-40B4-BE49-F238E27FC236}">
                <a16:creationId xmlns:a16="http://schemas.microsoft.com/office/drawing/2014/main" id="{8444DA4E-CB29-261D-BBB8-4C6631F20122}"/>
              </a:ext>
            </a:extLst>
          </p:cNvPr>
          <p:cNvSpPr txBox="1"/>
          <p:nvPr/>
        </p:nvSpPr>
        <p:spPr>
          <a:xfrm>
            <a:off x="4187314" y="1725627"/>
            <a:ext cx="2321129" cy="615553"/>
          </a:xfrm>
          <a:prstGeom prst="rect">
            <a:avLst/>
          </a:prstGeom>
          <a:noFill/>
        </p:spPr>
        <p:txBody>
          <a:bodyPr wrap="square">
            <a:spAutoFit/>
          </a:bodyPr>
          <a:lstStyle/>
          <a:p>
            <a:pPr algn="ctr"/>
            <a:r>
              <a:rPr lang="en-US" sz="1800" kern="1200">
                <a:solidFill>
                  <a:schemeClr val="tx1"/>
                </a:solidFill>
                <a:effectLst/>
                <a:latin typeface="+mn-lt"/>
                <a:ea typeface="+mn-ea"/>
                <a:cs typeface="+mn-cs"/>
              </a:rPr>
              <a:t>Image </a:t>
            </a:r>
            <a:r>
              <a:rPr lang="en-US"/>
              <a:t>2</a:t>
            </a:r>
            <a:r>
              <a:rPr lang="en-US" sz="1800" kern="1200">
                <a:solidFill>
                  <a:schemeClr val="tx1"/>
                </a:solidFill>
                <a:effectLst/>
                <a:latin typeface="+mn-lt"/>
                <a:ea typeface="+mn-ea"/>
                <a:cs typeface="+mn-cs"/>
              </a:rPr>
              <a:t> -</a:t>
            </a:r>
            <a:r>
              <a:rPr lang="en-US" sz="1600" kern="1200">
                <a:solidFill>
                  <a:schemeClr val="tx1"/>
                </a:solidFill>
                <a:effectLst/>
                <a:latin typeface="+mn-lt"/>
                <a:ea typeface="+mn-ea"/>
                <a:cs typeface="+mn-cs"/>
              </a:rPr>
              <a:t> </a:t>
            </a:r>
          </a:p>
          <a:p>
            <a:pPr algn="ctr"/>
            <a:r>
              <a:rPr lang="en-US" sz="1600" kern="1200">
                <a:solidFill>
                  <a:schemeClr val="tx1"/>
                </a:solidFill>
                <a:effectLst/>
                <a:latin typeface="+mn-lt"/>
                <a:ea typeface="+mn-ea"/>
                <a:cs typeface="+mn-cs"/>
              </a:rPr>
              <a:t>TestFlight Invitation</a:t>
            </a:r>
            <a:endParaRPr lang="en-US" sz="1600"/>
          </a:p>
        </p:txBody>
      </p:sp>
      <p:sp>
        <p:nvSpPr>
          <p:cNvPr id="26" name="TextBox 25">
            <a:extLst>
              <a:ext uri="{FF2B5EF4-FFF2-40B4-BE49-F238E27FC236}">
                <a16:creationId xmlns:a16="http://schemas.microsoft.com/office/drawing/2014/main" id="{D1B855C3-F55D-32CC-59AD-4D821999C7E7}"/>
              </a:ext>
            </a:extLst>
          </p:cNvPr>
          <p:cNvSpPr txBox="1"/>
          <p:nvPr/>
        </p:nvSpPr>
        <p:spPr>
          <a:xfrm>
            <a:off x="7277762" y="1725627"/>
            <a:ext cx="2321129" cy="615553"/>
          </a:xfrm>
          <a:prstGeom prst="rect">
            <a:avLst/>
          </a:prstGeom>
          <a:noFill/>
        </p:spPr>
        <p:txBody>
          <a:bodyPr wrap="square">
            <a:spAutoFit/>
          </a:bodyPr>
          <a:lstStyle/>
          <a:p>
            <a:pPr algn="ctr"/>
            <a:r>
              <a:rPr lang="en-US" sz="1800" kern="1200">
                <a:solidFill>
                  <a:schemeClr val="tx1"/>
                </a:solidFill>
                <a:effectLst/>
                <a:latin typeface="+mn-lt"/>
                <a:ea typeface="+mn-ea"/>
                <a:cs typeface="+mn-cs"/>
              </a:rPr>
              <a:t>Image 3 - </a:t>
            </a:r>
          </a:p>
          <a:p>
            <a:pPr algn="ctr"/>
            <a:r>
              <a:rPr lang="en-US" sz="1600" kern="1200">
                <a:solidFill>
                  <a:schemeClr val="tx1"/>
                </a:solidFill>
                <a:effectLst/>
                <a:latin typeface="+mn-lt"/>
                <a:ea typeface="+mn-ea"/>
                <a:cs typeface="+mn-cs"/>
              </a:rPr>
              <a:t>Copy Redemption Code</a:t>
            </a:r>
            <a:endParaRPr lang="en-US" sz="1600"/>
          </a:p>
        </p:txBody>
      </p:sp>
    </p:spTree>
    <p:extLst>
      <p:ext uri="{BB962C8B-B14F-4D97-AF65-F5344CB8AC3E}">
        <p14:creationId xmlns:p14="http://schemas.microsoft.com/office/powerpoint/2010/main" val="22224945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BA21FA-EF09-37F2-41C1-2CFD787E771D}"/>
              </a:ext>
            </a:extLst>
          </p:cNvPr>
          <p:cNvSpPr>
            <a:spLocks noGrp="1"/>
          </p:cNvSpPr>
          <p:nvPr>
            <p:ph type="title"/>
          </p:nvPr>
        </p:nvSpPr>
        <p:spPr>
          <a:xfrm>
            <a:off x="103866" y="174625"/>
            <a:ext cx="11264444" cy="1285198"/>
          </a:xfrm>
        </p:spPr>
        <p:txBody>
          <a:bodyPr>
            <a:normAutofit fontScale="90000"/>
          </a:bodyPr>
          <a:lstStyle/>
          <a:p>
            <a:pPr>
              <a:lnSpc>
                <a:spcPct val="100000"/>
              </a:lnSpc>
              <a:spcBef>
                <a:spcPts val="0"/>
              </a:spcBef>
            </a:pPr>
            <a:r>
              <a:rPr lang="en-US" sz="2200" b="1" i="1" dirty="0">
                <a:latin typeface="Calibri"/>
                <a:ea typeface="Calibri"/>
                <a:cs typeface="Times New Roman"/>
              </a:rPr>
              <a:t>Redeem</a:t>
            </a:r>
            <a:r>
              <a:rPr lang="en-US" sz="2200" b="1" i="1" dirty="0">
                <a:effectLst/>
                <a:latin typeface="Calibri"/>
                <a:ea typeface="Calibri"/>
                <a:cs typeface="Times New Roman"/>
              </a:rPr>
              <a:t> the Invite Code &amp; Launch App</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r>
              <a:rPr lang="en-US" sz="1800" dirty="0">
                <a:effectLst/>
                <a:latin typeface="Calibri"/>
                <a:ea typeface="Calibri"/>
                <a:cs typeface="Times New Roman"/>
              </a:rPr>
              <a:t>4. After Redeeming your code (Image 5), Install and open the app</a:t>
            </a:r>
            <a:r>
              <a:rPr lang="en-US" sz="1800" dirty="0">
                <a:latin typeface="Calibri"/>
                <a:ea typeface="Calibri"/>
                <a:cs typeface="Times New Roman"/>
              </a:rPr>
              <a:t> </a:t>
            </a:r>
            <a:r>
              <a:rPr lang="en-US" sz="1800" dirty="0">
                <a:effectLst/>
                <a:latin typeface="Calibri"/>
                <a:ea typeface="Calibri"/>
                <a:cs typeface="Times New Roman"/>
              </a:rPr>
              <a:t>(Image 6 &amp; 7)</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r>
              <a:rPr lang="en-US" sz="1800" dirty="0">
                <a:effectLst/>
                <a:latin typeface="Calibri"/>
                <a:ea typeface="Calibri"/>
                <a:cs typeface="Times New Roman"/>
              </a:rPr>
              <a:t>5. Click ‘Next’ and ‘Start Testing’ in the subsequent screens</a:t>
            </a:r>
            <a:r>
              <a:rPr lang="en-US" sz="1800" dirty="0">
                <a:latin typeface="Calibri"/>
                <a:ea typeface="Calibri"/>
                <a:cs typeface="Times New Roman"/>
              </a:rPr>
              <a:t> (</a:t>
            </a:r>
            <a:r>
              <a:rPr lang="en-US" sz="1800" dirty="0">
                <a:effectLst/>
                <a:latin typeface="Calibri"/>
                <a:ea typeface="Calibri"/>
                <a:cs typeface="Times New Roman"/>
              </a:rPr>
              <a:t>not shown here) </a:t>
            </a:r>
            <a:br>
              <a:rPr lang="en-US" sz="1800" dirty="0">
                <a:effectLst/>
                <a:latin typeface="Calibri" panose="020F0502020204030204" pitchFamily="34" charset="0"/>
                <a:ea typeface="Calibri" panose="020F0502020204030204" pitchFamily="34" charset="0"/>
                <a:cs typeface="Times New Roman" panose="02020603050405020304" pitchFamily="18" charset="0"/>
              </a:rPr>
            </a:br>
            <a:r>
              <a:rPr lang="en-US" sz="1800" dirty="0">
                <a:effectLst/>
                <a:latin typeface="Calibri"/>
                <a:ea typeface="Calibri"/>
                <a:cs typeface="Times New Roman"/>
              </a:rPr>
              <a:t>6. You have now successfully downloaded the App (Image 8). I</a:t>
            </a:r>
            <a:r>
              <a:rPr lang="en-US" sz="1800" dirty="0">
                <a:latin typeface="Calibri"/>
                <a:ea typeface="Calibri"/>
                <a:cs typeface="Times New Roman"/>
              </a:rPr>
              <a:t>t’s time to ‘Sign Up’ and start using the App</a:t>
            </a:r>
            <a:br>
              <a:rPr lang="en-US" sz="1800" dirty="0">
                <a:latin typeface="Calibri"/>
                <a:cs typeface="Times New Roman"/>
              </a:rPr>
            </a:br>
            <a:endParaRPr lang="en-US">
              <a:cs typeface="Calibri Light" panose="020F0302020204030204"/>
            </a:endParaRPr>
          </a:p>
        </p:txBody>
      </p:sp>
      <p:sp>
        <p:nvSpPr>
          <p:cNvPr id="4" name="Slide Number Placeholder 3">
            <a:extLst>
              <a:ext uri="{FF2B5EF4-FFF2-40B4-BE49-F238E27FC236}">
                <a16:creationId xmlns:a16="http://schemas.microsoft.com/office/drawing/2014/main" id="{7E494B51-7559-89ED-1931-B82CB4CF476E}"/>
              </a:ext>
            </a:extLst>
          </p:cNvPr>
          <p:cNvSpPr>
            <a:spLocks noGrp="1"/>
          </p:cNvSpPr>
          <p:nvPr>
            <p:ph type="sldNum" sz="quarter" idx="12"/>
          </p:nvPr>
        </p:nvSpPr>
        <p:spPr>
          <a:xfrm>
            <a:off x="9078685" y="6320492"/>
            <a:ext cx="2743200" cy="365125"/>
          </a:xfrm>
        </p:spPr>
        <p:txBody>
          <a:bodyPr/>
          <a:lstStyle/>
          <a:p>
            <a:r>
              <a:rPr lang="en-US"/>
              <a:t>Page </a:t>
            </a:r>
            <a:fld id="{CE3DC82A-4763-0846-9702-01F3D3003FD6}" type="slidenum">
              <a:rPr lang="en-US" smtClean="0"/>
              <a:pPr/>
              <a:t>3</a:t>
            </a:fld>
            <a:endParaRPr lang="en-US"/>
          </a:p>
        </p:txBody>
      </p:sp>
      <p:sp>
        <p:nvSpPr>
          <p:cNvPr id="3" name="TextBox 2">
            <a:extLst>
              <a:ext uri="{FF2B5EF4-FFF2-40B4-BE49-F238E27FC236}">
                <a16:creationId xmlns:a16="http://schemas.microsoft.com/office/drawing/2014/main" id="{C22FDA56-5E71-F99C-DC9B-15F3491CF4A2}"/>
              </a:ext>
            </a:extLst>
          </p:cNvPr>
          <p:cNvSpPr txBox="1"/>
          <p:nvPr/>
        </p:nvSpPr>
        <p:spPr>
          <a:xfrm>
            <a:off x="157139" y="1220490"/>
            <a:ext cx="2251889" cy="86177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t>Image 4 - </a:t>
            </a:r>
          </a:p>
          <a:p>
            <a:pPr algn="ctr"/>
            <a:r>
              <a:rPr lang="en-US" sz="1600"/>
              <a:t>Launch TestFlight, and tap Redeem </a:t>
            </a:r>
            <a:endParaRPr lang="en-US" sz="1600">
              <a:cs typeface="Calibri"/>
            </a:endParaRPr>
          </a:p>
        </p:txBody>
      </p:sp>
      <p:sp>
        <p:nvSpPr>
          <p:cNvPr id="11" name="TextBox 10">
            <a:extLst>
              <a:ext uri="{FF2B5EF4-FFF2-40B4-BE49-F238E27FC236}">
                <a16:creationId xmlns:a16="http://schemas.microsoft.com/office/drawing/2014/main" id="{D2143986-AE7C-1B78-A2BA-45F229799339}"/>
              </a:ext>
            </a:extLst>
          </p:cNvPr>
          <p:cNvSpPr txBox="1"/>
          <p:nvPr/>
        </p:nvSpPr>
        <p:spPr>
          <a:xfrm>
            <a:off x="2588265" y="1220490"/>
            <a:ext cx="2527800" cy="86177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t>Image 5 -   </a:t>
            </a:r>
            <a:br>
              <a:rPr lang="en-US"/>
            </a:br>
            <a:r>
              <a:rPr lang="en-US" sz="1600"/>
              <a:t>Paste the redeem code in the popup. Tap Redeem</a:t>
            </a:r>
            <a:endParaRPr lang="en-US" sz="1600">
              <a:cs typeface="Calibri" panose="020F0502020204030204"/>
            </a:endParaRPr>
          </a:p>
        </p:txBody>
      </p:sp>
      <p:sp>
        <p:nvSpPr>
          <p:cNvPr id="12" name="TextBox 11">
            <a:extLst>
              <a:ext uri="{FF2B5EF4-FFF2-40B4-BE49-F238E27FC236}">
                <a16:creationId xmlns:a16="http://schemas.microsoft.com/office/drawing/2014/main" id="{033F9AE3-43C5-3DF2-221E-AA962CE80191}"/>
              </a:ext>
            </a:extLst>
          </p:cNvPr>
          <p:cNvSpPr txBox="1"/>
          <p:nvPr/>
        </p:nvSpPr>
        <p:spPr>
          <a:xfrm>
            <a:off x="4716421" y="1220490"/>
            <a:ext cx="2743200" cy="61555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t>  </a:t>
            </a:r>
            <a:r>
              <a:rPr lang="en-US">
                <a:ea typeface="+mn-lt"/>
                <a:cs typeface="+mn-lt"/>
              </a:rPr>
              <a:t> Image 6 -   </a:t>
            </a:r>
            <a:br>
              <a:rPr lang="en-US"/>
            </a:br>
            <a:r>
              <a:rPr lang="en-US" sz="1600">
                <a:ea typeface="+mn-lt"/>
                <a:cs typeface="+mn-lt"/>
              </a:rPr>
              <a:t>Tap Install </a:t>
            </a:r>
          </a:p>
        </p:txBody>
      </p:sp>
      <p:grpSp>
        <p:nvGrpSpPr>
          <p:cNvPr id="34" name="Group 33">
            <a:extLst>
              <a:ext uri="{FF2B5EF4-FFF2-40B4-BE49-F238E27FC236}">
                <a16:creationId xmlns:a16="http://schemas.microsoft.com/office/drawing/2014/main" id="{6A809B0F-84F3-42DF-5186-EBB7C9709C0F}"/>
              </a:ext>
            </a:extLst>
          </p:cNvPr>
          <p:cNvGrpSpPr/>
          <p:nvPr/>
        </p:nvGrpSpPr>
        <p:grpSpPr>
          <a:xfrm>
            <a:off x="2707760" y="2243790"/>
            <a:ext cx="2057400" cy="4114800"/>
            <a:chOff x="6571397" y="2738849"/>
            <a:chExt cx="1808307" cy="3913630"/>
          </a:xfrm>
        </p:grpSpPr>
        <p:pic>
          <p:nvPicPr>
            <p:cNvPr id="8" name="Picture 7" descr="Graphical user interface, text, application, chat or text message&#10;&#10;Description automatically generated">
              <a:extLst>
                <a:ext uri="{FF2B5EF4-FFF2-40B4-BE49-F238E27FC236}">
                  <a16:creationId xmlns:a16="http://schemas.microsoft.com/office/drawing/2014/main" id="{C122189F-C76A-95BF-ACA1-4CE96D718080}"/>
                </a:ext>
              </a:extLst>
            </p:cNvPr>
            <p:cNvPicPr>
              <a:picLocks noChangeAspect="1"/>
            </p:cNvPicPr>
            <p:nvPr/>
          </p:nvPicPr>
          <p:blipFill>
            <a:blip r:embed="rId2"/>
            <a:srcRect/>
            <a:stretch/>
          </p:blipFill>
          <p:spPr>
            <a:xfrm>
              <a:off x="6571397" y="2738849"/>
              <a:ext cx="1808307" cy="3913630"/>
            </a:xfrm>
            <a:prstGeom prst="rect">
              <a:avLst/>
            </a:prstGeom>
          </p:spPr>
        </p:pic>
        <p:cxnSp>
          <p:nvCxnSpPr>
            <p:cNvPr id="13" name="Straight Arrow Connector 12">
              <a:extLst>
                <a:ext uri="{FF2B5EF4-FFF2-40B4-BE49-F238E27FC236}">
                  <a16:creationId xmlns:a16="http://schemas.microsoft.com/office/drawing/2014/main" id="{21598EE8-BD82-2BC5-1FE0-5F19F8B99D08}"/>
                </a:ext>
              </a:extLst>
            </p:cNvPr>
            <p:cNvCxnSpPr>
              <a:cxnSpLocks/>
            </p:cNvCxnSpPr>
            <p:nvPr/>
          </p:nvCxnSpPr>
          <p:spPr>
            <a:xfrm flipH="1" flipV="1">
              <a:off x="7469431" y="4186999"/>
              <a:ext cx="604694" cy="272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A1BA36EF-0F95-D3E7-7515-C4A3ECD99183}"/>
                </a:ext>
              </a:extLst>
            </p:cNvPr>
            <p:cNvCxnSpPr>
              <a:cxnSpLocks/>
            </p:cNvCxnSpPr>
            <p:nvPr/>
          </p:nvCxnSpPr>
          <p:spPr>
            <a:xfrm flipH="1" flipV="1">
              <a:off x="7977431" y="4516258"/>
              <a:ext cx="244882" cy="386481"/>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7" name="Rectangle: Rounded Corners 26">
              <a:extLst>
                <a:ext uri="{FF2B5EF4-FFF2-40B4-BE49-F238E27FC236}">
                  <a16:creationId xmlns:a16="http://schemas.microsoft.com/office/drawing/2014/main" id="{21FCEA5E-EDEE-18FC-73DE-B54C01C9C17A}"/>
                </a:ext>
              </a:extLst>
            </p:cNvPr>
            <p:cNvSpPr/>
            <p:nvPr/>
          </p:nvSpPr>
          <p:spPr>
            <a:xfrm>
              <a:off x="7516519" y="4327407"/>
              <a:ext cx="479777" cy="169333"/>
            </a:xfrm>
            <a:prstGeom prst="round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9" name="Group 18">
            <a:extLst>
              <a:ext uri="{FF2B5EF4-FFF2-40B4-BE49-F238E27FC236}">
                <a16:creationId xmlns:a16="http://schemas.microsoft.com/office/drawing/2014/main" id="{B2E92C65-B03F-B809-5B59-2378283931D8}"/>
              </a:ext>
            </a:extLst>
          </p:cNvPr>
          <p:cNvGrpSpPr/>
          <p:nvPr/>
        </p:nvGrpSpPr>
        <p:grpSpPr>
          <a:xfrm>
            <a:off x="5063892" y="2214787"/>
            <a:ext cx="2057400" cy="4114800"/>
            <a:chOff x="6382028" y="2214787"/>
            <a:chExt cx="1992291" cy="4143855"/>
          </a:xfrm>
        </p:grpSpPr>
        <p:sp>
          <p:nvSpPr>
            <p:cNvPr id="23" name="Rectangle 22">
              <a:extLst>
                <a:ext uri="{FF2B5EF4-FFF2-40B4-BE49-F238E27FC236}">
                  <a16:creationId xmlns:a16="http://schemas.microsoft.com/office/drawing/2014/main" id="{17E5F9B0-89C1-DC72-D958-25F38B67156D}"/>
                </a:ext>
              </a:extLst>
            </p:cNvPr>
            <p:cNvSpPr/>
            <p:nvPr/>
          </p:nvSpPr>
          <p:spPr>
            <a:xfrm>
              <a:off x="6382028" y="2214787"/>
              <a:ext cx="1992291" cy="4143855"/>
            </a:xfrm>
            <a:prstGeom prst="rect">
              <a:avLst/>
            </a:prstGeom>
            <a:noFill/>
            <a:ln>
              <a:solidFill>
                <a:srgbClr val="4472C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5" name="Group 34">
              <a:extLst>
                <a:ext uri="{FF2B5EF4-FFF2-40B4-BE49-F238E27FC236}">
                  <a16:creationId xmlns:a16="http://schemas.microsoft.com/office/drawing/2014/main" id="{D72028B9-DB27-C6D2-7F67-ED9B1D8F756C}"/>
                </a:ext>
              </a:extLst>
            </p:cNvPr>
            <p:cNvGrpSpPr/>
            <p:nvPr/>
          </p:nvGrpSpPr>
          <p:grpSpPr>
            <a:xfrm>
              <a:off x="6432550" y="2251382"/>
              <a:ext cx="1870331" cy="3975655"/>
              <a:chOff x="9338915" y="2831249"/>
              <a:chExt cx="1774834" cy="3829952"/>
            </a:xfrm>
          </p:grpSpPr>
          <p:pic>
            <p:nvPicPr>
              <p:cNvPr id="6" name="Content Placeholder 4" descr="Graphical user interface, text, application&#10;&#10;Description automatically generated">
                <a:extLst>
                  <a:ext uri="{FF2B5EF4-FFF2-40B4-BE49-F238E27FC236}">
                    <a16:creationId xmlns:a16="http://schemas.microsoft.com/office/drawing/2014/main" id="{1ED602B8-0F1B-563D-759D-DA4E0ADDB086}"/>
                  </a:ext>
                </a:extLst>
              </p:cNvPr>
              <p:cNvPicPr>
                <a:picLocks noChangeAspect="1"/>
              </p:cNvPicPr>
              <p:nvPr/>
            </p:nvPicPr>
            <p:blipFill>
              <a:blip r:embed="rId3"/>
              <a:stretch>
                <a:fillRect/>
              </a:stretch>
            </p:blipFill>
            <p:spPr>
              <a:xfrm>
                <a:off x="9338915" y="2831249"/>
                <a:ext cx="1774834" cy="3829952"/>
              </a:xfrm>
              <a:prstGeom prst="rect">
                <a:avLst/>
              </a:prstGeom>
            </p:spPr>
          </p:pic>
          <p:sp>
            <p:nvSpPr>
              <p:cNvPr id="28" name="Rectangle: Rounded Corners 27">
                <a:extLst>
                  <a:ext uri="{FF2B5EF4-FFF2-40B4-BE49-F238E27FC236}">
                    <a16:creationId xmlns:a16="http://schemas.microsoft.com/office/drawing/2014/main" id="{2A1D7F85-AF8F-22F2-70D1-C48A37874B7D}"/>
                  </a:ext>
                </a:extLst>
              </p:cNvPr>
              <p:cNvSpPr/>
              <p:nvPr/>
            </p:nvSpPr>
            <p:spPr>
              <a:xfrm>
                <a:off x="10038663" y="3708349"/>
                <a:ext cx="479777" cy="197556"/>
              </a:xfrm>
              <a:prstGeom prst="round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9" name="Straight Arrow Connector 28">
                <a:extLst>
                  <a:ext uri="{FF2B5EF4-FFF2-40B4-BE49-F238E27FC236}">
                    <a16:creationId xmlns:a16="http://schemas.microsoft.com/office/drawing/2014/main" id="{57407973-B760-3643-93C2-6F182B2237C8}"/>
                  </a:ext>
                </a:extLst>
              </p:cNvPr>
              <p:cNvCxnSpPr>
                <a:cxnSpLocks/>
              </p:cNvCxnSpPr>
              <p:nvPr/>
            </p:nvCxnSpPr>
            <p:spPr>
              <a:xfrm flipH="1" flipV="1">
                <a:off x="10545653" y="3829518"/>
                <a:ext cx="378917" cy="162646"/>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grpSp>
        <p:nvGrpSpPr>
          <p:cNvPr id="26" name="Group 25">
            <a:extLst>
              <a:ext uri="{FF2B5EF4-FFF2-40B4-BE49-F238E27FC236}">
                <a16:creationId xmlns:a16="http://schemas.microsoft.com/office/drawing/2014/main" id="{477E199E-3E85-288D-EC55-E0206AFE6A78}"/>
              </a:ext>
            </a:extLst>
          </p:cNvPr>
          <p:cNvGrpSpPr/>
          <p:nvPr/>
        </p:nvGrpSpPr>
        <p:grpSpPr>
          <a:xfrm>
            <a:off x="351628" y="2216401"/>
            <a:ext cx="2057400" cy="4114800"/>
            <a:chOff x="349782" y="2216471"/>
            <a:chExt cx="2048895" cy="4171391"/>
          </a:xfrm>
        </p:grpSpPr>
        <p:grpSp>
          <p:nvGrpSpPr>
            <p:cNvPr id="33" name="Group 32">
              <a:extLst>
                <a:ext uri="{FF2B5EF4-FFF2-40B4-BE49-F238E27FC236}">
                  <a16:creationId xmlns:a16="http://schemas.microsoft.com/office/drawing/2014/main" id="{EA271BFC-95DB-A719-6AEE-8C54763C75DB}"/>
                </a:ext>
              </a:extLst>
            </p:cNvPr>
            <p:cNvGrpSpPr/>
            <p:nvPr/>
          </p:nvGrpSpPr>
          <p:grpSpPr>
            <a:xfrm>
              <a:off x="349782" y="2216471"/>
              <a:ext cx="2048895" cy="4171391"/>
              <a:chOff x="3659763" y="2739238"/>
              <a:chExt cx="1960291" cy="3914438"/>
            </a:xfrm>
          </p:grpSpPr>
          <p:pic>
            <p:nvPicPr>
              <p:cNvPr id="18" name="Picture 7" descr="Graphical user interface, text, application&#10;&#10;Description automatically generated">
                <a:extLst>
                  <a:ext uri="{FF2B5EF4-FFF2-40B4-BE49-F238E27FC236}">
                    <a16:creationId xmlns:a16="http://schemas.microsoft.com/office/drawing/2014/main" id="{FCA7724E-2E02-8394-E5D0-7B41AD4125BC}"/>
                  </a:ext>
                </a:extLst>
              </p:cNvPr>
              <p:cNvPicPr>
                <a:picLocks noChangeAspect="1"/>
              </p:cNvPicPr>
              <p:nvPr/>
            </p:nvPicPr>
            <p:blipFill>
              <a:blip r:embed="rId4"/>
              <a:stretch>
                <a:fillRect/>
              </a:stretch>
            </p:blipFill>
            <p:spPr>
              <a:xfrm>
                <a:off x="3728014" y="2798688"/>
                <a:ext cx="1811886" cy="3814840"/>
              </a:xfrm>
              <a:prstGeom prst="rect">
                <a:avLst/>
              </a:prstGeom>
            </p:spPr>
          </p:pic>
          <p:sp>
            <p:nvSpPr>
              <p:cNvPr id="20" name="Rectangle 19">
                <a:extLst>
                  <a:ext uri="{FF2B5EF4-FFF2-40B4-BE49-F238E27FC236}">
                    <a16:creationId xmlns:a16="http://schemas.microsoft.com/office/drawing/2014/main" id="{F007A05E-F4D2-B9AE-B625-3837D8EE666A}"/>
                  </a:ext>
                </a:extLst>
              </p:cNvPr>
              <p:cNvSpPr/>
              <p:nvPr/>
            </p:nvSpPr>
            <p:spPr>
              <a:xfrm>
                <a:off x="3659763" y="2739238"/>
                <a:ext cx="1960291" cy="3914438"/>
              </a:xfrm>
              <a:prstGeom prst="rect">
                <a:avLst/>
              </a:pr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0" name="Rectangle: Rounded Corners 29">
              <a:extLst>
                <a:ext uri="{FF2B5EF4-FFF2-40B4-BE49-F238E27FC236}">
                  <a16:creationId xmlns:a16="http://schemas.microsoft.com/office/drawing/2014/main" id="{4EC8C6A5-BACC-924B-C61A-FAB11C87AC5B}"/>
                </a:ext>
              </a:extLst>
            </p:cNvPr>
            <p:cNvSpPr/>
            <p:nvPr/>
          </p:nvSpPr>
          <p:spPr>
            <a:xfrm>
              <a:off x="960303" y="4610693"/>
              <a:ext cx="827851" cy="310444"/>
            </a:xfrm>
            <a:prstGeom prst="round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1" name="Straight Arrow Connector 30">
              <a:extLst>
                <a:ext uri="{FF2B5EF4-FFF2-40B4-BE49-F238E27FC236}">
                  <a16:creationId xmlns:a16="http://schemas.microsoft.com/office/drawing/2014/main" id="{BE16404F-273D-41DE-346C-36F624DE3D0B}"/>
                </a:ext>
              </a:extLst>
            </p:cNvPr>
            <p:cNvCxnSpPr>
              <a:cxnSpLocks/>
            </p:cNvCxnSpPr>
            <p:nvPr/>
          </p:nvCxnSpPr>
          <p:spPr>
            <a:xfrm flipH="1" flipV="1">
              <a:off x="1794203" y="4913470"/>
              <a:ext cx="595287" cy="228497"/>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pic>
        <p:nvPicPr>
          <p:cNvPr id="16" name="Content Placeholder 3">
            <a:extLst>
              <a:ext uri="{FF2B5EF4-FFF2-40B4-BE49-F238E27FC236}">
                <a16:creationId xmlns:a16="http://schemas.microsoft.com/office/drawing/2014/main" id="{D6F77575-8E59-F7CE-E9C5-67B53E95751D}"/>
              </a:ext>
            </a:extLst>
          </p:cNvPr>
          <p:cNvPicPr>
            <a:picLocks noGrp="1" noChangeAspect="1"/>
          </p:cNvPicPr>
          <p:nvPr/>
        </p:nvPicPr>
        <p:blipFill>
          <a:blip r:embed="rId5"/>
          <a:srcRect/>
          <a:stretch/>
        </p:blipFill>
        <p:spPr>
          <a:xfrm>
            <a:off x="7420023" y="2214787"/>
            <a:ext cx="2039934" cy="4114800"/>
          </a:xfrm>
          <a:prstGeom prst="rect">
            <a:avLst/>
          </a:prstGeom>
        </p:spPr>
      </p:pic>
      <p:sp>
        <p:nvSpPr>
          <p:cNvPr id="17" name="TextBox 2">
            <a:extLst>
              <a:ext uri="{FF2B5EF4-FFF2-40B4-BE49-F238E27FC236}">
                <a16:creationId xmlns:a16="http://schemas.microsoft.com/office/drawing/2014/main" id="{AFD94C4B-036E-BF18-5DA9-60B39794D29A}"/>
              </a:ext>
            </a:extLst>
          </p:cNvPr>
          <p:cNvSpPr txBox="1"/>
          <p:nvPr/>
        </p:nvSpPr>
        <p:spPr>
          <a:xfrm>
            <a:off x="7575014" y="1220490"/>
            <a:ext cx="1606459" cy="615553"/>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ea typeface="+mn-lt"/>
                <a:cs typeface="+mn-lt"/>
              </a:rPr>
              <a:t>Image 7 - </a:t>
            </a:r>
          </a:p>
          <a:p>
            <a:pPr algn="ctr"/>
            <a:r>
              <a:rPr lang="en-US" sz="1600">
                <a:ea typeface="+mn-lt"/>
                <a:cs typeface="+mn-lt"/>
              </a:rPr>
              <a:t>Tap ‘Open’</a:t>
            </a:r>
            <a:endParaRPr lang="en-US" sz="1600">
              <a:cs typeface="Calibri" panose="020F0502020204030204"/>
            </a:endParaRPr>
          </a:p>
        </p:txBody>
      </p:sp>
      <p:pic>
        <p:nvPicPr>
          <p:cNvPr id="21" name="Picture 20">
            <a:extLst>
              <a:ext uri="{FF2B5EF4-FFF2-40B4-BE49-F238E27FC236}">
                <a16:creationId xmlns:a16="http://schemas.microsoft.com/office/drawing/2014/main" id="{357BA3E3-7395-A78E-E3A0-75E89AF46E98}"/>
              </a:ext>
            </a:extLst>
          </p:cNvPr>
          <p:cNvPicPr>
            <a:picLocks noChangeAspect="1"/>
          </p:cNvPicPr>
          <p:nvPr/>
        </p:nvPicPr>
        <p:blipFill>
          <a:blip r:embed="rId6"/>
          <a:srcRect/>
          <a:stretch/>
        </p:blipFill>
        <p:spPr>
          <a:xfrm>
            <a:off x="9758688" y="2225133"/>
            <a:ext cx="2003086" cy="4114800"/>
          </a:xfrm>
          <a:prstGeom prst="rect">
            <a:avLst/>
          </a:prstGeom>
        </p:spPr>
      </p:pic>
      <p:sp>
        <p:nvSpPr>
          <p:cNvPr id="22" name="TextBox 2">
            <a:extLst>
              <a:ext uri="{FF2B5EF4-FFF2-40B4-BE49-F238E27FC236}">
                <a16:creationId xmlns:a16="http://schemas.microsoft.com/office/drawing/2014/main" id="{0B663273-4B52-2ADB-B1C3-79CA40E4D9CB}"/>
              </a:ext>
            </a:extLst>
          </p:cNvPr>
          <p:cNvSpPr txBox="1"/>
          <p:nvPr/>
        </p:nvSpPr>
        <p:spPr>
          <a:xfrm>
            <a:off x="9758688" y="1220490"/>
            <a:ext cx="1609622" cy="369332"/>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ea typeface="+mn-lt"/>
                <a:cs typeface="+mn-lt"/>
              </a:rPr>
              <a:t>Image 8</a:t>
            </a:r>
            <a:endParaRPr lang="en-US">
              <a:cs typeface="Calibri" panose="020F0502020204030204"/>
            </a:endParaRPr>
          </a:p>
        </p:txBody>
      </p:sp>
    </p:spTree>
    <p:extLst>
      <p:ext uri="{BB962C8B-B14F-4D97-AF65-F5344CB8AC3E}">
        <p14:creationId xmlns:p14="http://schemas.microsoft.com/office/powerpoint/2010/main" val="43041926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TaxCatchAll xmlns="a83b073f-d86e-41b7-ad30-5baef5bc130d" xsi:nil="true"/>
    <lcf76f155ced4ddcb4097134ff3c332f xmlns="50c263cc-6d61-4db9-9a8c-d40c1daabb80">
      <Terms xmlns="http://schemas.microsoft.com/office/infopath/2007/PartnerControls"/>
    </lcf76f155ced4ddcb4097134ff3c332f>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2D4560CE0781894181834A7D6D3BA483" ma:contentTypeVersion="13" ma:contentTypeDescription="Create a new document." ma:contentTypeScope="" ma:versionID="11c4796e0fc180578d5fbde99898076d">
  <xsd:schema xmlns:xsd="http://www.w3.org/2001/XMLSchema" xmlns:xs="http://www.w3.org/2001/XMLSchema" xmlns:p="http://schemas.microsoft.com/office/2006/metadata/properties" xmlns:ns2="50c263cc-6d61-4db9-9a8c-d40c1daabb80" xmlns:ns3="a83b073f-d86e-41b7-ad30-5baef5bc130d" targetNamespace="http://schemas.microsoft.com/office/2006/metadata/properties" ma:root="true" ma:fieldsID="56a94afa784f77b5a7aa8cf7886e79f1" ns2:_="" ns3:_="">
    <xsd:import namespace="50c263cc-6d61-4db9-9a8c-d40c1daabb80"/>
    <xsd:import namespace="a83b073f-d86e-41b7-ad30-5baef5bc130d"/>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lcf76f155ced4ddcb4097134ff3c332f" minOccurs="0"/>
                <xsd:element ref="ns3:TaxCatchAll" minOccurs="0"/>
                <xsd:element ref="ns2:MediaServiceObjectDetectorVersions" minOccurs="0"/>
                <xsd:element ref="ns2:MediaServiceOCR" minOccurs="0"/>
                <xsd:element ref="ns2:MediaServiceGenerationTime" minOccurs="0"/>
                <xsd:element ref="ns2:MediaServiceEventHashCode" minOccurs="0"/>
                <xsd:element ref="ns3:SharedWithUsers" minOccurs="0"/>
                <xsd:element ref="ns3:SharedWithDetails" minOccurs="0"/>
                <xsd:element ref="ns2:MediaServiceDateTake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0c263cc-6d61-4db9-9a8c-d40c1daabb80"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lcf76f155ced4ddcb4097134ff3c332f" ma:index="12" nillable="true" ma:taxonomy="true" ma:internalName="lcf76f155ced4ddcb4097134ff3c332f" ma:taxonomyFieldName="MediaServiceImageTags" ma:displayName="Image Tags" ma:readOnly="false" ma:fieldId="{5cf76f15-5ced-4ddc-b409-7134ff3c332f}" ma:taxonomyMulti="true" ma:sspId="45ffce1f-ef76-446e-81f5-643a5e2cef9a"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14" nillable="true" ma:displayName="MediaServiceObjectDetectorVersions" ma:hidden="true" ma:indexed="true" ma:internalName="MediaServiceObjectDetectorVersion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DateTaken" ma:index="20" nillable="true" ma:displayName="MediaServiceDateTaken" ma:hidden="true" ma:indexed="true" ma:internalName="MediaServiceDateTake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a83b073f-d86e-41b7-ad30-5baef5bc130d" elementFormDefault="qualified">
    <xsd:import namespace="http://schemas.microsoft.com/office/2006/documentManagement/types"/>
    <xsd:import namespace="http://schemas.microsoft.com/office/infopath/2007/PartnerControls"/>
    <xsd:element name="TaxCatchAll" ma:index="13" nillable="true" ma:displayName="Taxonomy Catch All Column" ma:hidden="true" ma:list="{f0e8097c-7e01-412f-95dd-9373295b3a2a}" ma:internalName="TaxCatchAll" ma:showField="CatchAllData" ma:web="a83b073f-d86e-41b7-ad30-5baef5bc130d">
      <xsd:complexType>
        <xsd:complexContent>
          <xsd:extension base="dms:MultiChoiceLookup">
            <xsd:sequence>
              <xsd:element name="Value" type="dms:Lookup" maxOccurs="unbounded" minOccurs="0" nillable="true"/>
            </xsd:sequence>
          </xsd:extension>
        </xsd:complexContent>
      </xsd:complexType>
    </xsd:element>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FF20714-C95C-454E-8D39-73224D5602E0}">
  <ds:schemaRefs>
    <ds:schemaRef ds:uri="50c263cc-6d61-4db9-9a8c-d40c1daabb80"/>
    <ds:schemaRef ds:uri="a83b073f-d86e-41b7-ad30-5baef5bc130d"/>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27FA8A8B-E517-4BB3-9F6A-544B6C028339}">
  <ds:schemaRefs>
    <ds:schemaRef ds:uri="50c263cc-6d61-4db9-9a8c-d40c1daabb80"/>
    <ds:schemaRef ds:uri="a83b073f-d86e-41b7-ad30-5baef5bc130d"/>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C84FBA67-C97D-40F7-8AF3-4F627F913FA5}">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Application>Microsoft Office PowerPoint</Application>
  <PresentationFormat>Widescreen</PresentationFormat>
  <Slides>3</Slides>
  <Notes>1</Notes>
  <HiddenSlides>0</HiddenSlides>
  <ScaleCrop>false</ScaleCrop>
  <HeadingPairs>
    <vt:vector size="4" baseType="variant">
      <vt:variant>
        <vt:lpstr>Theme</vt:lpstr>
      </vt:variant>
      <vt:variant>
        <vt:i4>1</vt:i4>
      </vt:variant>
      <vt:variant>
        <vt:lpstr>Slide Titles</vt:lpstr>
      </vt:variant>
      <vt:variant>
        <vt:i4>3</vt:i4>
      </vt:variant>
    </vt:vector>
  </HeadingPairs>
  <TitlesOfParts>
    <vt:vector size="4" baseType="lpstr">
      <vt:lpstr>Office Theme</vt:lpstr>
      <vt:lpstr>Otsuka Mindful Tea Ritual App iOS Installation Instructions </vt:lpstr>
      <vt:lpstr>   TestFlight Installation  TestFlight is a platform created by Apple that allows developers to distribute beta versions of their iOS apps to a limited number of testers before releasing them to the public on the App Store.   Please download and open TestFlight through the App Store. Be sure to allow notifications when prompted and agree to the Terms and Conditions in the TestFlight App. For additional details, please see https://testflight.apple.com/ section: Installing a beta iOS or iPadOS app via email or public link invitation  </vt:lpstr>
      <vt:lpstr>Redeem the Invite Code &amp; Launch App 4. After Redeeming your code (Image 5), Install and open the app (Image 6 &amp; 7) 5. Click ‘Next’ and ‘Start Testing’ in the subsequent screens (not shown here)  6. You have now successfully downloaded the App (Image 8). It’s time to ‘Sign Up’ and start using the App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tsuka Lotus Meditation Tea App iOS Installation Instructions </dc:title>
  <dc:creator>Microsoft Office User</dc:creator>
  <cp:revision>3</cp:revision>
  <dcterms:created xsi:type="dcterms:W3CDTF">2023-03-02T23:47:29Z</dcterms:created>
  <dcterms:modified xsi:type="dcterms:W3CDTF">2024-05-08T23:48:5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D4560CE0781894181834A7D6D3BA483</vt:lpwstr>
  </property>
  <property fmtid="{D5CDD505-2E9C-101B-9397-08002B2CF9AE}" pid="3" name="MediaServiceImageTags">
    <vt:lpwstr/>
  </property>
</Properties>
</file>